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9322E4D-B240-4CFA-856E-9D7708E03A80}" v="275" dt="2025-10-24T15:51:39.1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22" autoAdjust="0"/>
    <p:restoredTop sz="94684"/>
  </p:normalViewPr>
  <p:slideViewPr>
    <p:cSldViewPr snapToGrid="0">
      <p:cViewPr>
        <p:scale>
          <a:sx n="130" d="100"/>
          <a:sy n="130" d="100"/>
        </p:scale>
        <p:origin x="69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netto, Andrea" userId="da2261fe-c884-4386-a584-05ce7944f5b0" providerId="ADAL" clId="{DABC0169-BAE4-4F28-ABA3-1BF2B51AFAF9}"/>
    <pc:docChg chg="modSld">
      <pc:chgData name="Bonetto, Andrea" userId="da2261fe-c884-4386-a584-05ce7944f5b0" providerId="ADAL" clId="{DABC0169-BAE4-4F28-ABA3-1BF2B51AFAF9}" dt="2025-08-05T20:16:46.515" v="96" actId="114"/>
      <pc:docMkLst>
        <pc:docMk/>
      </pc:docMkLst>
      <pc:sldChg chg="addSp delSp modSp mod">
        <pc:chgData name="Bonetto, Andrea" userId="da2261fe-c884-4386-a584-05ce7944f5b0" providerId="ADAL" clId="{DABC0169-BAE4-4F28-ABA3-1BF2B51AFAF9}" dt="2025-08-05T20:16:46.515" v="96" actId="114"/>
        <pc:sldMkLst>
          <pc:docMk/>
          <pc:sldMk cId="1681351875" sldId="257"/>
        </pc:sldMkLst>
      </pc:sldChg>
    </pc:docChg>
  </pc:docChgLst>
  <pc:docChgLst>
    <pc:chgData name="Bonetto, Andrea" userId="da2261fe-c884-4386-a584-05ce7944f5b0" providerId="ADAL" clId="{F197EFD6-C5CA-4A45-8F53-4143399E4A76}"/>
    <pc:docChg chg="custSel addSld modSld">
      <pc:chgData name="Bonetto, Andrea" userId="da2261fe-c884-4386-a584-05ce7944f5b0" providerId="ADAL" clId="{F197EFD6-C5CA-4A45-8F53-4143399E4A76}" dt="2025-07-31T18:12:07.618" v="1010" actId="164"/>
      <pc:docMkLst>
        <pc:docMk/>
      </pc:docMkLst>
      <pc:sldChg chg="addSp delSp modSp mod">
        <pc:chgData name="Bonetto, Andrea" userId="da2261fe-c884-4386-a584-05ce7944f5b0" providerId="ADAL" clId="{F197EFD6-C5CA-4A45-8F53-4143399E4A76}" dt="2025-07-31T18:12:07.618" v="1010" actId="164"/>
        <pc:sldMkLst>
          <pc:docMk/>
          <pc:sldMk cId="1681351875" sldId="257"/>
        </pc:sldMkLst>
      </pc:sldChg>
      <pc:sldChg chg="addSp delSp modSp new mod">
        <pc:chgData name="Bonetto, Andrea" userId="da2261fe-c884-4386-a584-05ce7944f5b0" providerId="ADAL" clId="{F197EFD6-C5CA-4A45-8F53-4143399E4A76}" dt="2025-07-31T18:11:58.553" v="1009" actId="164"/>
        <pc:sldMkLst>
          <pc:docMk/>
          <pc:sldMk cId="1605436578" sldId="258"/>
        </pc:sldMkLst>
      </pc:sldChg>
    </pc:docChg>
  </pc:docChgLst>
  <pc:docChgLst>
    <pc:chgData name="Bonetto, Andrea" userId="da2261fe-c884-4386-a584-05ce7944f5b0" providerId="ADAL" clId="{800AAAD2-1C14-4AF9-BF70-7299C838D77C}"/>
    <pc:docChg chg="undo custSel addSld delSld modSld">
      <pc:chgData name="Bonetto, Andrea" userId="da2261fe-c884-4386-a584-05ce7944f5b0" providerId="ADAL" clId="{800AAAD2-1C14-4AF9-BF70-7299C838D77C}" dt="2025-10-24T15:51:43.657" v="2931" actId="1036"/>
      <pc:docMkLst>
        <pc:docMk/>
      </pc:docMkLst>
      <pc:sldChg chg="addSp modSp add mod">
        <pc:chgData name="Bonetto, Andrea" userId="da2261fe-c884-4386-a584-05ce7944f5b0" providerId="ADAL" clId="{800AAAD2-1C14-4AF9-BF70-7299C838D77C}" dt="2025-10-08T19:47:50.220" v="433" actId="20577"/>
        <pc:sldMkLst>
          <pc:docMk/>
          <pc:sldMk cId="2200558421" sldId="256"/>
        </pc:sldMkLst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2" creationId="{3695C8D6-A892-C31E-1EA3-5CF71C7B99CA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3" creationId="{AEE20316-B250-8F95-8502-4AB6C5D2A631}"/>
          </ac:spMkLst>
        </pc:spChg>
        <pc:spChg chg="mod">
          <ac:chgData name="Bonetto, Andrea" userId="da2261fe-c884-4386-a584-05ce7944f5b0" providerId="ADAL" clId="{800AAAD2-1C14-4AF9-BF70-7299C838D77C}" dt="2025-10-08T19:47:50.220" v="433" actId="20577"/>
          <ac:spMkLst>
            <pc:docMk/>
            <pc:sldMk cId="2200558421" sldId="256"/>
            <ac:spMk id="4" creationId="{CEFB8432-FEBE-B872-6B35-4314A8086D36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6" creationId="{50E8E322-29A7-045A-FFF9-28672E812767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7" creationId="{4C200E89-4E55-B521-3614-5FD290B6A346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8" creationId="{7BEDCEFA-1ABE-A88D-DF0A-ECE01EEF8470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9" creationId="{23F99594-6F43-8617-31A4-0FA5EA256C13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10" creationId="{D953BD1F-85E6-9BF2-5C11-CA7B51E76300}"/>
          </ac:spMkLst>
        </pc:spChg>
        <pc:spChg chg="add mod">
          <ac:chgData name="Bonetto, Andrea" userId="da2261fe-c884-4386-a584-05ce7944f5b0" providerId="ADAL" clId="{800AAAD2-1C14-4AF9-BF70-7299C838D77C}" dt="2025-10-08T17:28:49.642" v="90" actId="164"/>
          <ac:spMkLst>
            <pc:docMk/>
            <pc:sldMk cId="2200558421" sldId="256"/>
            <ac:spMk id="11" creationId="{BA92B4B7-09EB-E486-ABBE-D8FFD8D5E8FC}"/>
          </ac:spMkLst>
        </pc:spChg>
        <pc:grpChg chg="add mod">
          <ac:chgData name="Bonetto, Andrea" userId="da2261fe-c884-4386-a584-05ce7944f5b0" providerId="ADAL" clId="{800AAAD2-1C14-4AF9-BF70-7299C838D77C}" dt="2025-10-08T17:28:49.642" v="90" actId="164"/>
          <ac:grpSpMkLst>
            <pc:docMk/>
            <pc:sldMk cId="2200558421" sldId="256"/>
            <ac:grpSpMk id="12" creationId="{3DE5FD47-112C-D277-8363-4BB0E2809E18}"/>
          </ac:grpSpMkLst>
        </pc:grpChg>
        <pc:graphicFrameChg chg="mod">
          <ac:chgData name="Bonetto, Andrea" userId="da2261fe-c884-4386-a584-05ce7944f5b0" providerId="ADAL" clId="{800AAAD2-1C14-4AF9-BF70-7299C838D77C}" dt="2025-10-08T17:28:49.642" v="90" actId="164"/>
          <ac:graphicFrameMkLst>
            <pc:docMk/>
            <pc:sldMk cId="2200558421" sldId="256"/>
            <ac:graphicFrameMk id="5" creationId="{37021811-730A-1B63-B0C6-3C31CB06CE59}"/>
          </ac:graphicFrameMkLst>
        </pc:graphicFrameChg>
      </pc:sldChg>
      <pc:sldChg chg="addSp delSp modSp mod">
        <pc:chgData name="Bonetto, Andrea" userId="da2261fe-c884-4386-a584-05ce7944f5b0" providerId="ADAL" clId="{800AAAD2-1C14-4AF9-BF70-7299C838D77C}" dt="2025-10-24T15:51:19.106" v="2900" actId="12788"/>
        <pc:sldMkLst>
          <pc:docMk/>
          <pc:sldMk cId="1681351875" sldId="257"/>
        </pc:sldMkLst>
        <pc:spChg chg="del mod topLvl">
          <ac:chgData name="Bonetto, Andrea" userId="da2261fe-c884-4386-a584-05ce7944f5b0" providerId="ADAL" clId="{800AAAD2-1C14-4AF9-BF70-7299C838D77C}" dt="2025-10-24T14:51:45.489" v="609" actId="478"/>
          <ac:spMkLst>
            <pc:docMk/>
            <pc:sldMk cId="1681351875" sldId="257"/>
            <ac:spMk id="2" creationId="{DB0CE275-86A1-CD91-4D2F-98B4E3B666E6}"/>
          </ac:spMkLst>
        </pc:spChg>
        <pc:spChg chg="del mod topLvl">
          <ac:chgData name="Bonetto, Andrea" userId="da2261fe-c884-4386-a584-05ce7944f5b0" providerId="ADAL" clId="{800AAAD2-1C14-4AF9-BF70-7299C838D77C}" dt="2025-10-24T14:51:46.947" v="610" actId="478"/>
          <ac:spMkLst>
            <pc:docMk/>
            <pc:sldMk cId="1681351875" sldId="257"/>
            <ac:spMk id="3" creationId="{45E58873-F653-88F9-99E4-9E8EA136B253}"/>
          </ac:spMkLst>
        </pc:spChg>
        <pc:spChg chg="del mod topLvl">
          <ac:chgData name="Bonetto, Andrea" userId="da2261fe-c884-4386-a584-05ce7944f5b0" providerId="ADAL" clId="{800AAAD2-1C14-4AF9-BF70-7299C838D77C}" dt="2025-10-24T14:52:08.218" v="618" actId="478"/>
          <ac:spMkLst>
            <pc:docMk/>
            <pc:sldMk cId="1681351875" sldId="257"/>
            <ac:spMk id="6" creationId="{F9F49D51-2C3D-5C84-968E-73D37A75FE25}"/>
          </ac:spMkLst>
        </pc:spChg>
        <pc:spChg chg="del mod topLvl">
          <ac:chgData name="Bonetto, Andrea" userId="da2261fe-c884-4386-a584-05ce7944f5b0" providerId="ADAL" clId="{800AAAD2-1C14-4AF9-BF70-7299C838D77C}" dt="2025-10-24T14:52:09.908" v="619" actId="478"/>
          <ac:spMkLst>
            <pc:docMk/>
            <pc:sldMk cId="1681351875" sldId="257"/>
            <ac:spMk id="7" creationId="{E2D22BF9-16B9-A2F0-06CC-EC2BDC2D059F}"/>
          </ac:spMkLst>
        </pc:spChg>
        <pc:spChg chg="mod topLvl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8" creationId="{3A5DAEF4-A651-4DCD-35F4-97805E619026}"/>
          </ac:spMkLst>
        </pc:spChg>
        <pc:spChg chg="mod topLvl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9" creationId="{6B6A5D9C-AE96-7164-516A-7E9452FCE52E}"/>
          </ac:spMkLst>
        </pc:spChg>
        <pc:spChg chg="add del mod topLvl">
          <ac:chgData name="Bonetto, Andrea" userId="da2261fe-c884-4386-a584-05ce7944f5b0" providerId="ADAL" clId="{800AAAD2-1C14-4AF9-BF70-7299C838D77C}" dt="2025-10-24T14:59:36.978" v="991" actId="478"/>
          <ac:spMkLst>
            <pc:docMk/>
            <pc:sldMk cId="1681351875" sldId="257"/>
            <ac:spMk id="10" creationId="{A73B3616-46A8-0027-0A48-8432241D5B6B}"/>
          </ac:spMkLst>
        </pc:spChg>
        <pc:spChg chg="add mod">
          <ac:chgData name="Bonetto, Andrea" userId="da2261fe-c884-4386-a584-05ce7944f5b0" providerId="ADAL" clId="{800AAAD2-1C14-4AF9-BF70-7299C838D77C}" dt="2025-10-24T14:47:39.671" v="600" actId="1076"/>
          <ac:spMkLst>
            <pc:docMk/>
            <pc:sldMk cId="1681351875" sldId="257"/>
            <ac:spMk id="12" creationId="{120BC326-F297-D4E9-8BC7-681AC0DCDE66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14" creationId="{65C49E7A-33D1-B6BE-B526-F81B66EE86DD}"/>
          </ac:spMkLst>
        </pc:spChg>
        <pc:spChg chg="del mod topLvl">
          <ac:chgData name="Bonetto, Andrea" userId="da2261fe-c884-4386-a584-05ce7944f5b0" providerId="ADAL" clId="{800AAAD2-1C14-4AF9-BF70-7299C838D77C}" dt="2025-10-24T14:46:20.223" v="533" actId="478"/>
          <ac:spMkLst>
            <pc:docMk/>
            <pc:sldMk cId="1681351875" sldId="257"/>
            <ac:spMk id="15" creationId="{04CDFB27-99EE-4B21-C3BE-B355472312BA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16" creationId="{FF89F6CC-5EF0-4422-C006-225AE2657AC3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19" creationId="{3B233A91-1098-7E7E-BB33-9E5130EDEF8B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20" creationId="{E0654FCF-545C-4F10-5450-298150A188F8}"/>
          </ac:spMkLst>
        </pc:spChg>
        <pc:spChg chg="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21" creationId="{77E58CAA-AF46-6EA1-6BAD-33A79A8DDF15}"/>
          </ac:spMkLst>
        </pc:spChg>
        <pc:spChg chg="del mod topLvl">
          <ac:chgData name="Bonetto, Andrea" userId="da2261fe-c884-4386-a584-05ce7944f5b0" providerId="ADAL" clId="{800AAAD2-1C14-4AF9-BF70-7299C838D77C}" dt="2025-10-24T14:57:05.201" v="978" actId="478"/>
          <ac:spMkLst>
            <pc:docMk/>
            <pc:sldMk cId="1681351875" sldId="257"/>
            <ac:spMk id="22" creationId="{EB31F3A5-9446-442B-324F-1085F4902C11}"/>
          </ac:spMkLst>
        </pc:spChg>
        <pc:spChg chg="del mod topLvl">
          <ac:chgData name="Bonetto, Andrea" userId="da2261fe-c884-4386-a584-05ce7944f5b0" providerId="ADAL" clId="{800AAAD2-1C14-4AF9-BF70-7299C838D77C}" dt="2025-10-24T14:51:43.375" v="608" actId="478"/>
          <ac:spMkLst>
            <pc:docMk/>
            <pc:sldMk cId="1681351875" sldId="257"/>
            <ac:spMk id="23" creationId="{3ADD623C-CC95-F6F0-E6CB-9E1DB5F82C18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25" creationId="{270E2B1F-4621-251A-3D59-5BF031AA91AE}"/>
          </ac:spMkLst>
        </pc:spChg>
        <pc:spChg chg="add del mod">
          <ac:chgData name="Bonetto, Andrea" userId="da2261fe-c884-4386-a584-05ce7944f5b0" providerId="ADAL" clId="{800AAAD2-1C14-4AF9-BF70-7299C838D77C}" dt="2025-10-24T14:51:51.268" v="611" actId="21"/>
          <ac:spMkLst>
            <pc:docMk/>
            <pc:sldMk cId="1681351875" sldId="257"/>
            <ac:spMk id="26" creationId="{CB328EBC-88C9-2DAF-A43C-26126A599213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27" creationId="{60E62A87-5B90-E115-81E5-E523857904D8}"/>
          </ac:spMkLst>
        </pc:spChg>
        <pc:spChg chg="add mod">
          <ac:chgData name="Bonetto, Andrea" userId="da2261fe-c884-4386-a584-05ce7944f5b0" providerId="ADAL" clId="{800AAAD2-1C14-4AF9-BF70-7299C838D77C}" dt="2025-10-24T14:54:47.103" v="900" actId="408"/>
          <ac:spMkLst>
            <pc:docMk/>
            <pc:sldMk cId="1681351875" sldId="257"/>
            <ac:spMk id="28" creationId="{86216205-41A7-35B1-2C42-1A47A3FAC53E}"/>
          </ac:spMkLst>
        </pc:spChg>
        <pc:spChg chg="add mod">
          <ac:chgData name="Bonetto, Andrea" userId="da2261fe-c884-4386-a584-05ce7944f5b0" providerId="ADAL" clId="{800AAAD2-1C14-4AF9-BF70-7299C838D77C}" dt="2025-10-24T15:01:34.511" v="1006" actId="164"/>
          <ac:spMkLst>
            <pc:docMk/>
            <pc:sldMk cId="1681351875" sldId="257"/>
            <ac:spMk id="29" creationId="{BBC172C9-1B49-36D8-DFB7-1CCDA0CA26BC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30" creationId="{D6A15358-A13C-32DC-C4EE-9BA9B7425826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31" creationId="{81C21108-38B1-9330-0426-B552A3E46F4B}"/>
          </ac:spMkLst>
        </pc:spChg>
        <pc:spChg chg="add mod">
          <ac:chgData name="Bonetto, Andrea" userId="da2261fe-c884-4386-a584-05ce7944f5b0" providerId="ADAL" clId="{800AAAD2-1C14-4AF9-BF70-7299C838D77C}" dt="2025-10-24T15:01:34.511" v="1006" actId="164"/>
          <ac:spMkLst>
            <pc:docMk/>
            <pc:sldMk cId="1681351875" sldId="257"/>
            <ac:spMk id="32" creationId="{F09E0A53-FEA9-F72A-A697-65A181DA258A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33" creationId="{B9F93166-1B32-95B2-A6B2-FB1476F8153B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34" creationId="{42EC1570-3A8E-390D-2E33-DF95D85705F4}"/>
          </ac:spMkLst>
        </pc:spChg>
        <pc:spChg chg="add mod">
          <ac:chgData name="Bonetto, Andrea" userId="da2261fe-c884-4386-a584-05ce7944f5b0" providerId="ADAL" clId="{800AAAD2-1C14-4AF9-BF70-7299C838D77C}" dt="2025-10-24T15:01:34.511" v="1006" actId="164"/>
          <ac:spMkLst>
            <pc:docMk/>
            <pc:sldMk cId="1681351875" sldId="257"/>
            <ac:spMk id="35" creationId="{A9947FA0-6BB6-631E-FF0B-1D08916EA662}"/>
          </ac:spMkLst>
        </pc:spChg>
        <pc:spChg chg="add mod">
          <ac:chgData name="Bonetto, Andrea" userId="da2261fe-c884-4386-a584-05ce7944f5b0" providerId="ADAL" clId="{800AAAD2-1C14-4AF9-BF70-7299C838D77C}" dt="2025-10-24T15:50:21.177" v="2859" actId="165"/>
          <ac:spMkLst>
            <pc:docMk/>
            <pc:sldMk cId="1681351875" sldId="257"/>
            <ac:spMk id="36" creationId="{EFD8E644-C96E-0AE0-0514-07A58C81F6E2}"/>
          </ac:spMkLst>
        </pc:spChg>
        <pc:spChg chg="add mod">
          <ac:chgData name="Bonetto, Andrea" userId="da2261fe-c884-4386-a584-05ce7944f5b0" providerId="ADAL" clId="{800AAAD2-1C14-4AF9-BF70-7299C838D77C}" dt="2025-10-24T15:01:34.511" v="1006" actId="164"/>
          <ac:spMkLst>
            <pc:docMk/>
            <pc:sldMk cId="1681351875" sldId="257"/>
            <ac:spMk id="40" creationId="{912FA778-BB31-DF82-6331-B24893E2DFDF}"/>
          </ac:spMkLst>
        </pc:spChg>
        <pc:spChg chg="add mod">
          <ac:chgData name="Bonetto, Andrea" userId="da2261fe-c884-4386-a584-05ce7944f5b0" providerId="ADAL" clId="{800AAAD2-1C14-4AF9-BF70-7299C838D77C}" dt="2025-10-24T15:01:34.511" v="1006" actId="164"/>
          <ac:spMkLst>
            <pc:docMk/>
            <pc:sldMk cId="1681351875" sldId="257"/>
            <ac:spMk id="41" creationId="{33BE8610-BAFC-9FEF-CBC3-C2DD98E16252}"/>
          </ac:spMkLst>
        </pc:spChg>
        <pc:spChg chg="add mod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42" creationId="{277F1DE4-B291-539D-ED79-433E70109FEB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45" creationId="{7E0486D4-E177-7CA3-2D98-C272E718A773}"/>
          </ac:spMkLst>
        </pc:spChg>
        <pc:spChg chg="mod">
          <ac:chgData name="Bonetto, Andrea" userId="da2261fe-c884-4386-a584-05ce7944f5b0" providerId="ADAL" clId="{800AAAD2-1C14-4AF9-BF70-7299C838D77C}" dt="2025-10-24T15:50:43.596" v="2877" actId="165"/>
          <ac:spMkLst>
            <pc:docMk/>
            <pc:sldMk cId="1681351875" sldId="257"/>
            <ac:spMk id="46" creationId="{11102B79-90DE-CA8B-3B59-A35D1FDEF5BA}"/>
          </ac:spMkLst>
        </pc:spChg>
        <pc:spChg chg="mod">
          <ac:chgData name="Bonetto, Andrea" userId="da2261fe-c884-4386-a584-05ce7944f5b0" providerId="ADAL" clId="{800AAAD2-1C14-4AF9-BF70-7299C838D77C}" dt="2025-10-24T15:50:43.596" v="2877" actId="165"/>
          <ac:spMkLst>
            <pc:docMk/>
            <pc:sldMk cId="1681351875" sldId="257"/>
            <ac:spMk id="47" creationId="{F6B4651A-DB0A-C8B0-C5B0-111737E000A4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48" creationId="{6A2D0D52-9174-E903-8CAF-AFD52B198004}"/>
          </ac:spMkLst>
        </pc:spChg>
        <pc:spChg chg="mod">
          <ac:chgData name="Bonetto, Andrea" userId="da2261fe-c884-4386-a584-05ce7944f5b0" providerId="ADAL" clId="{800AAAD2-1C14-4AF9-BF70-7299C838D77C}" dt="2025-10-24T15:50:43.596" v="2877" actId="165"/>
          <ac:spMkLst>
            <pc:docMk/>
            <pc:sldMk cId="1681351875" sldId="257"/>
            <ac:spMk id="49" creationId="{B0A1F06D-F77B-72E4-FA4E-596AC655CAD6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51" creationId="{72CA0F22-496D-1F8C-B104-042C2987E32B}"/>
          </ac:spMkLst>
        </pc:spChg>
        <pc:spChg chg="mod">
          <ac:chgData name="Bonetto, Andrea" userId="da2261fe-c884-4386-a584-05ce7944f5b0" providerId="ADAL" clId="{800AAAD2-1C14-4AF9-BF70-7299C838D77C}" dt="2025-10-24T15:50:43.596" v="2877" actId="165"/>
          <ac:spMkLst>
            <pc:docMk/>
            <pc:sldMk cId="1681351875" sldId="257"/>
            <ac:spMk id="52" creationId="{1EEDFAAD-87C5-7D1F-6828-71EA04B2624D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53" creationId="{3DC68430-DD3D-CB92-FD2A-ECCA880318D9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54" creationId="{5262D5D2-7C19-9826-CF69-9A5872FCFA59}"/>
          </ac:spMkLst>
        </pc:spChg>
        <pc:spChg chg="mod">
          <ac:chgData name="Bonetto, Andrea" userId="da2261fe-c884-4386-a584-05ce7944f5b0" providerId="ADAL" clId="{800AAAD2-1C14-4AF9-BF70-7299C838D77C}" dt="2025-10-24T15:01:46.783" v="1040"/>
          <ac:spMkLst>
            <pc:docMk/>
            <pc:sldMk cId="1681351875" sldId="257"/>
            <ac:spMk id="57" creationId="{EE6A4503-3BDD-FD64-B66A-FE03F6BFBFE9}"/>
          </ac:spMkLst>
        </pc:spChg>
        <pc:spChg chg="mod">
          <ac:chgData name="Bonetto, Andrea" userId="da2261fe-c884-4386-a584-05ce7944f5b0" providerId="ADAL" clId="{800AAAD2-1C14-4AF9-BF70-7299C838D77C}" dt="2025-10-24T15:50:43.596" v="2877" actId="165"/>
          <ac:spMkLst>
            <pc:docMk/>
            <pc:sldMk cId="1681351875" sldId="257"/>
            <ac:spMk id="58" creationId="{645E540B-29A7-98B9-F91C-C95ACD954CB6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0" creationId="{98D1E6C3-1A7D-1005-2B34-4ADC211F017F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1" creationId="{C24A45A6-6892-376A-A057-6F48474F24A9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2" creationId="{B1ECC18D-4F6E-459F-E23A-4838E6FD0C95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3" creationId="{6D06C570-21BC-9DA4-0245-13453526CA4C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4" creationId="{8E137A36-A91F-70E9-4C58-D236DA8EF38E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5" creationId="{11123976-C113-1596-51D1-9249084A6831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66" creationId="{6C47295B-2A25-B9D2-5417-B94763658C85}"/>
          </ac:spMkLst>
        </pc:spChg>
        <pc:spChg chg="add mod topLvl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67" creationId="{6B18E3D1-C67F-6F82-F5D7-B506C7462971}"/>
          </ac:spMkLst>
        </pc:spChg>
        <pc:spChg chg="add mod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68" creationId="{04BA4646-8D30-1BB4-5CFF-C136CA786D05}"/>
          </ac:spMkLst>
        </pc:spChg>
        <pc:spChg chg="add mod topLvl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69" creationId="{534EB215-6A23-5AE7-5F82-A8C44E328889}"/>
          </ac:spMkLst>
        </pc:spChg>
        <pc:spChg chg="add mod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70" creationId="{35EBD1A6-0930-39A5-58B6-14EF865891F8}"/>
          </ac:spMkLst>
        </pc:spChg>
        <pc:spChg chg="add mod topLvl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71" creationId="{E9DAC92A-8A34-2BCB-ECC5-CFCFB8F14366}"/>
          </ac:spMkLst>
        </pc:spChg>
        <pc:spChg chg="add mod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72" creationId="{55898023-A3E6-36A9-7657-AEF37539E252}"/>
          </ac:spMkLst>
        </pc:spChg>
        <pc:spChg chg="add mod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73" creationId="{5E900801-1592-3BF4-2363-7DB2948C3AEA}"/>
          </ac:spMkLst>
        </pc:spChg>
        <pc:spChg chg="add mod">
          <ac:chgData name="Bonetto, Andrea" userId="da2261fe-c884-4386-a584-05ce7944f5b0" providerId="ADAL" clId="{800AAAD2-1C14-4AF9-BF70-7299C838D77C}" dt="2025-10-24T15:50:57.534" v="2895" actId="164"/>
          <ac:spMkLst>
            <pc:docMk/>
            <pc:sldMk cId="1681351875" sldId="257"/>
            <ac:spMk id="74" creationId="{DA35DB5E-C1E2-0DB1-ED23-091E8DF55295}"/>
          </ac:spMkLst>
        </pc:spChg>
        <pc:spChg chg="add mod topLvl">
          <ac:chgData name="Bonetto, Andrea" userId="da2261fe-c884-4386-a584-05ce7944f5b0" providerId="ADAL" clId="{800AAAD2-1C14-4AF9-BF70-7299C838D77C}" dt="2025-10-24T15:50:49.596" v="2878" actId="164"/>
          <ac:spMkLst>
            <pc:docMk/>
            <pc:sldMk cId="1681351875" sldId="257"/>
            <ac:spMk id="75" creationId="{8F317E3B-9269-980D-6FE2-4EFB8FD06E46}"/>
          </ac:spMkLst>
        </pc:spChg>
        <pc:grpChg chg="mod">
          <ac:chgData name="Bonetto, Andrea" userId="da2261fe-c884-4386-a584-05ce7944f5b0" providerId="ADAL" clId="{800AAAD2-1C14-4AF9-BF70-7299C838D77C}" dt="2025-10-24T15:02:04.133" v="1058" actId="164"/>
          <ac:grpSpMkLst>
            <pc:docMk/>
            <pc:sldMk cId="1681351875" sldId="257"/>
            <ac:grpSpMk id="43" creationId="{3CB0E1C6-80FE-AC2B-2299-68D75440F026}"/>
          </ac:grpSpMkLst>
        </pc:grpChg>
        <pc:grpChg chg="mod">
          <ac:chgData name="Bonetto, Andrea" userId="da2261fe-c884-4386-a584-05ce7944f5b0" providerId="ADAL" clId="{800AAAD2-1C14-4AF9-BF70-7299C838D77C}" dt="2025-10-24T15:02:04.133" v="1058" actId="164"/>
          <ac:grpSpMkLst>
            <pc:docMk/>
            <pc:sldMk cId="1681351875" sldId="257"/>
            <ac:grpSpMk id="44" creationId="{1D17102A-5995-33AB-9DA2-E5E3A624E2F5}"/>
          </ac:grpSpMkLst>
        </pc:grpChg>
        <pc:grpChg chg="add mod">
          <ac:chgData name="Bonetto, Andrea" userId="da2261fe-c884-4386-a584-05ce7944f5b0" providerId="ADAL" clId="{800AAAD2-1C14-4AF9-BF70-7299C838D77C}" dt="2025-10-24T15:02:06.072" v="1068" actId="1035"/>
          <ac:grpSpMkLst>
            <pc:docMk/>
            <pc:sldMk cId="1681351875" sldId="257"/>
            <ac:grpSpMk id="59" creationId="{474A8229-7795-F0CA-7420-6C1B88E8F15A}"/>
          </ac:grpSpMkLst>
        </pc:grpChg>
        <pc:grpChg chg="mod">
          <ac:chgData name="Bonetto, Andrea" userId="da2261fe-c884-4386-a584-05ce7944f5b0" providerId="ADAL" clId="{800AAAD2-1C14-4AF9-BF70-7299C838D77C}" dt="2025-10-24T15:50:39.934" v="2876" actId="1036"/>
          <ac:grpSpMkLst>
            <pc:docMk/>
            <pc:sldMk cId="1681351875" sldId="257"/>
            <ac:grpSpMk id="76" creationId="{D6AE8FB6-72F8-B468-411D-1804D91D683F}"/>
          </ac:grpSpMkLst>
        </pc:grpChg>
        <pc:grpChg chg="mod">
          <ac:chgData name="Bonetto, Andrea" userId="da2261fe-c884-4386-a584-05ce7944f5b0" providerId="ADAL" clId="{800AAAD2-1C14-4AF9-BF70-7299C838D77C}" dt="2025-10-24T15:51:16.805" v="2899" actId="164"/>
          <ac:grpSpMkLst>
            <pc:docMk/>
            <pc:sldMk cId="1681351875" sldId="257"/>
            <ac:grpSpMk id="77" creationId="{883DC877-2A89-80C0-83AB-24CE04377E99}"/>
          </ac:grpSpMkLst>
        </pc:grpChg>
        <pc:grpChg chg="mod">
          <ac:chgData name="Bonetto, Andrea" userId="da2261fe-c884-4386-a584-05ce7944f5b0" providerId="ADAL" clId="{800AAAD2-1C14-4AF9-BF70-7299C838D77C}" dt="2025-10-24T15:51:16.805" v="2899" actId="164"/>
          <ac:grpSpMkLst>
            <pc:docMk/>
            <pc:sldMk cId="1681351875" sldId="257"/>
            <ac:grpSpMk id="78" creationId="{7E590D9B-D5AC-F2E6-0BC8-E472E5CAF306}"/>
          </ac:grpSpMkLst>
        </pc:grpChg>
        <pc:grpChg chg="add mod">
          <ac:chgData name="Bonetto, Andrea" userId="da2261fe-c884-4386-a584-05ce7944f5b0" providerId="ADAL" clId="{800AAAD2-1C14-4AF9-BF70-7299C838D77C}" dt="2025-10-24T15:51:19.106" v="2900" actId="12788"/>
          <ac:grpSpMkLst>
            <pc:docMk/>
            <pc:sldMk cId="1681351875" sldId="257"/>
            <ac:grpSpMk id="79" creationId="{12670738-96E5-914C-EFB2-5D9954495694}"/>
          </ac:grpSpMkLst>
        </pc:grpChg>
        <pc:picChg chg="mod modCrop">
          <ac:chgData name="Bonetto, Andrea" userId="da2261fe-c884-4386-a584-05ce7944f5b0" providerId="ADAL" clId="{800AAAD2-1C14-4AF9-BF70-7299C838D77C}" dt="2025-10-24T15:09:20.979" v="1493" actId="732"/>
          <ac:picMkLst>
            <pc:docMk/>
            <pc:sldMk cId="1681351875" sldId="257"/>
            <ac:picMk id="4" creationId="{FBAB2912-00CE-1B7F-0960-48DE6DC1CDD5}"/>
          </ac:picMkLst>
        </pc:picChg>
        <pc:picChg chg="mod modCrop">
          <ac:chgData name="Bonetto, Andrea" userId="da2261fe-c884-4386-a584-05ce7944f5b0" providerId="ADAL" clId="{800AAAD2-1C14-4AF9-BF70-7299C838D77C}" dt="2025-10-24T15:36:26.626" v="1712"/>
          <ac:picMkLst>
            <pc:docMk/>
            <pc:sldMk cId="1681351875" sldId="257"/>
            <ac:picMk id="5" creationId="{F1AD7AEA-9180-16F7-8865-6E3E85691AE8}"/>
          </ac:picMkLst>
        </pc:picChg>
        <pc:picChg chg="add del mod modCrop">
          <ac:chgData name="Bonetto, Andrea" userId="da2261fe-c884-4386-a584-05ce7944f5b0" providerId="ADAL" clId="{800AAAD2-1C14-4AF9-BF70-7299C838D77C}" dt="2025-10-24T14:51:51.268" v="611" actId="21"/>
          <ac:picMkLst>
            <pc:docMk/>
            <pc:sldMk cId="1681351875" sldId="257"/>
            <ac:picMk id="11" creationId="{2B8392D5-352B-A279-542B-91B284E2931C}"/>
          </ac:picMkLst>
        </pc:picChg>
        <pc:picChg chg="add del mod modCrop">
          <ac:chgData name="Bonetto, Andrea" userId="da2261fe-c884-4386-a584-05ce7944f5b0" providerId="ADAL" clId="{800AAAD2-1C14-4AF9-BF70-7299C838D77C}" dt="2025-10-24T14:51:51.268" v="611" actId="21"/>
          <ac:picMkLst>
            <pc:docMk/>
            <pc:sldMk cId="1681351875" sldId="257"/>
            <ac:picMk id="13" creationId="{142EC758-12BC-2E5D-E2C0-BDEE0F844442}"/>
          </ac:picMkLst>
        </pc:picChg>
        <pc:cxnChg chg="del">
          <ac:chgData name="Bonetto, Andrea" userId="da2261fe-c884-4386-a584-05ce7944f5b0" providerId="ADAL" clId="{800AAAD2-1C14-4AF9-BF70-7299C838D77C}" dt="2025-10-24T14:51:39.820" v="605" actId="478"/>
          <ac:cxnSpMkLst>
            <pc:docMk/>
            <pc:sldMk cId="1681351875" sldId="257"/>
            <ac:cxnSpMk id="17" creationId="{EBB74A87-8629-C04D-3F4A-5930CDA59FF0}"/>
          </ac:cxnSpMkLst>
        </pc:cxnChg>
        <pc:cxnChg chg="del">
          <ac:chgData name="Bonetto, Andrea" userId="da2261fe-c884-4386-a584-05ce7944f5b0" providerId="ADAL" clId="{800AAAD2-1C14-4AF9-BF70-7299C838D77C}" dt="2025-10-24T14:51:41.134" v="606" actId="478"/>
          <ac:cxnSpMkLst>
            <pc:docMk/>
            <pc:sldMk cId="1681351875" sldId="257"/>
            <ac:cxnSpMk id="18" creationId="{C7887CAC-F15F-CB62-6074-ECF7C21807F4}"/>
          </ac:cxnSpMkLst>
        </pc:cxnChg>
        <pc:cxnChg chg="del">
          <ac:chgData name="Bonetto, Andrea" userId="da2261fe-c884-4386-a584-05ce7944f5b0" providerId="ADAL" clId="{800AAAD2-1C14-4AF9-BF70-7299C838D77C}" dt="2025-10-24T14:51:41.878" v="607" actId="478"/>
          <ac:cxnSpMkLst>
            <pc:docMk/>
            <pc:sldMk cId="1681351875" sldId="257"/>
            <ac:cxnSpMk id="24" creationId="{22186A9B-000D-9D36-9A3C-0C758954EA39}"/>
          </ac:cxnSpMkLst>
        </pc:cxnChg>
        <pc:cxnChg chg="add mod">
          <ac:chgData name="Bonetto, Andrea" userId="da2261fe-c884-4386-a584-05ce7944f5b0" providerId="ADAL" clId="{800AAAD2-1C14-4AF9-BF70-7299C838D77C}" dt="2025-10-24T14:55:31.717" v="923" actId="1035"/>
          <ac:cxnSpMkLst>
            <pc:docMk/>
            <pc:sldMk cId="1681351875" sldId="257"/>
            <ac:cxnSpMk id="38" creationId="{CE6F8625-E05F-37AD-5067-61968D0237E0}"/>
          </ac:cxnSpMkLst>
        </pc:cxnChg>
        <pc:cxnChg chg="add mod">
          <ac:chgData name="Bonetto, Andrea" userId="da2261fe-c884-4386-a584-05ce7944f5b0" providerId="ADAL" clId="{800AAAD2-1C14-4AF9-BF70-7299C838D77C}" dt="2025-10-24T14:55:31.717" v="923" actId="1035"/>
          <ac:cxnSpMkLst>
            <pc:docMk/>
            <pc:sldMk cId="1681351875" sldId="257"/>
            <ac:cxnSpMk id="39" creationId="{6A92FEBD-E8DA-D81A-187E-6B9A8390D596}"/>
          </ac:cxnSpMkLst>
        </pc:cxnChg>
      </pc:sldChg>
      <pc:sldChg chg="addSp delSp modSp mod">
        <pc:chgData name="Bonetto, Andrea" userId="da2261fe-c884-4386-a584-05ce7944f5b0" providerId="ADAL" clId="{800AAAD2-1C14-4AF9-BF70-7299C838D77C}" dt="2025-10-24T15:51:43.657" v="2931" actId="1036"/>
        <pc:sldMkLst>
          <pc:docMk/>
          <pc:sldMk cId="1605436578" sldId="258"/>
        </pc:sldMkLst>
        <pc:spChg chg="del mod topLvl">
          <ac:chgData name="Bonetto, Andrea" userId="da2261fe-c884-4386-a584-05ce7944f5b0" providerId="ADAL" clId="{800AAAD2-1C14-4AF9-BF70-7299C838D77C}" dt="2025-10-24T15:05:13.006" v="1194" actId="478"/>
          <ac:spMkLst>
            <pc:docMk/>
            <pc:sldMk cId="1605436578" sldId="258"/>
            <ac:spMk id="2" creationId="{553643BB-8A04-D9A9-F12C-1BEA5835636F}"/>
          </ac:spMkLst>
        </pc:spChg>
        <pc:spChg chg="del mod topLvl">
          <ac:chgData name="Bonetto, Andrea" userId="da2261fe-c884-4386-a584-05ce7944f5b0" providerId="ADAL" clId="{800AAAD2-1C14-4AF9-BF70-7299C838D77C}" dt="2025-10-24T15:05:11.349" v="1193" actId="478"/>
          <ac:spMkLst>
            <pc:docMk/>
            <pc:sldMk cId="1605436578" sldId="258"/>
            <ac:spMk id="3" creationId="{DD0E110D-80BF-5A1B-70BF-BC8FFCE53661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6" creationId="{FCC29AA9-A8FC-BFAA-0B18-D3F681520CC9}"/>
          </ac:spMkLst>
        </pc:spChg>
        <pc:spChg chg="del mod topLvl">
          <ac:chgData name="Bonetto, Andrea" userId="da2261fe-c884-4386-a584-05ce7944f5b0" providerId="ADAL" clId="{800AAAD2-1C14-4AF9-BF70-7299C838D77C}" dt="2025-10-24T15:07:42.558" v="1394" actId="478"/>
          <ac:spMkLst>
            <pc:docMk/>
            <pc:sldMk cId="1605436578" sldId="258"/>
            <ac:spMk id="7" creationId="{DA9C35EF-0DA5-A6F5-5848-DE5876EECFE9}"/>
          </ac:spMkLst>
        </pc:spChg>
        <pc:spChg chg="del mod topLvl">
          <ac:chgData name="Bonetto, Andrea" userId="da2261fe-c884-4386-a584-05ce7944f5b0" providerId="ADAL" clId="{800AAAD2-1C14-4AF9-BF70-7299C838D77C}" dt="2025-10-24T15:05:30.705" v="1196" actId="478"/>
          <ac:spMkLst>
            <pc:docMk/>
            <pc:sldMk cId="1605436578" sldId="258"/>
            <ac:spMk id="8" creationId="{8E283532-2808-385F-5319-927F94322D5F}"/>
          </ac:spMkLst>
        </pc:spChg>
        <pc:spChg chg="del mod topLvl">
          <ac:chgData name="Bonetto, Andrea" userId="da2261fe-c884-4386-a584-05ce7944f5b0" providerId="ADAL" clId="{800AAAD2-1C14-4AF9-BF70-7299C838D77C}" dt="2025-10-24T15:05:30.705" v="1196" actId="478"/>
          <ac:spMkLst>
            <pc:docMk/>
            <pc:sldMk cId="1605436578" sldId="258"/>
            <ac:spMk id="9" creationId="{613CFE1D-F8A5-6811-ADAF-848C6C0FAD10}"/>
          </ac:spMkLst>
        </pc:spChg>
        <pc:spChg chg="del mod topLvl">
          <ac:chgData name="Bonetto, Andrea" userId="da2261fe-c884-4386-a584-05ce7944f5b0" providerId="ADAL" clId="{800AAAD2-1C14-4AF9-BF70-7299C838D77C}" dt="2025-10-24T15:05:32.517" v="1197" actId="478"/>
          <ac:spMkLst>
            <pc:docMk/>
            <pc:sldMk cId="1605436578" sldId="258"/>
            <ac:spMk id="12" creationId="{C935A958-20C8-A5FA-24AF-C53FB910ED6E}"/>
          </ac:spMkLst>
        </pc:spChg>
        <pc:spChg chg="del mod topLvl">
          <ac:chgData name="Bonetto, Andrea" userId="da2261fe-c884-4386-a584-05ce7944f5b0" providerId="ADAL" clId="{800AAAD2-1C14-4AF9-BF70-7299C838D77C}" dt="2025-10-24T15:05:32.517" v="1197" actId="478"/>
          <ac:spMkLst>
            <pc:docMk/>
            <pc:sldMk cId="1605436578" sldId="258"/>
            <ac:spMk id="13" creationId="{13409AE4-385A-CAD0-6ACF-C06BF6BBDEDC}"/>
          </ac:spMkLst>
        </pc:spChg>
        <pc:spChg chg="mod topLvl">
          <ac:chgData name="Bonetto, Andrea" userId="da2261fe-c884-4386-a584-05ce7944f5b0" providerId="ADAL" clId="{800AAAD2-1C14-4AF9-BF70-7299C838D77C}" dt="2025-10-24T15:07:59.353" v="1436" actId="1037"/>
          <ac:spMkLst>
            <pc:docMk/>
            <pc:sldMk cId="1605436578" sldId="258"/>
            <ac:spMk id="17" creationId="{FF0DE09E-6F07-681B-BEE5-67D7FB4C9CD9}"/>
          </ac:spMkLst>
        </pc:spChg>
        <pc:spChg chg="del">
          <ac:chgData name="Bonetto, Andrea" userId="da2261fe-c884-4386-a584-05ce7944f5b0" providerId="ADAL" clId="{800AAAD2-1C14-4AF9-BF70-7299C838D77C}" dt="2025-10-24T15:04:55.768" v="1190" actId="478"/>
          <ac:spMkLst>
            <pc:docMk/>
            <pc:sldMk cId="1605436578" sldId="258"/>
            <ac:spMk id="18" creationId="{0E7B49DC-D8A1-7A97-6D28-1808A06C14B5}"/>
          </ac:spMkLst>
        </pc:spChg>
        <pc:spChg chg="mod topLvl">
          <ac:chgData name="Bonetto, Andrea" userId="da2261fe-c884-4386-a584-05ce7944f5b0" providerId="ADAL" clId="{800AAAD2-1C14-4AF9-BF70-7299C838D77C}" dt="2025-10-24T15:48:59.853" v="2787" actId="1037"/>
          <ac:spMkLst>
            <pc:docMk/>
            <pc:sldMk cId="1605436578" sldId="258"/>
            <ac:spMk id="19" creationId="{C7D95622-BAC2-AFAB-4C8C-410D19013A04}"/>
          </ac:spMkLst>
        </pc:spChg>
        <pc:spChg chg="add mod">
          <ac:chgData name="Bonetto, Andrea" userId="da2261fe-c884-4386-a584-05ce7944f5b0" providerId="ADAL" clId="{800AAAD2-1C14-4AF9-BF70-7299C838D77C}" dt="2025-10-24T15:04:42.715" v="1187"/>
          <ac:spMkLst>
            <pc:docMk/>
            <pc:sldMk cId="1605436578" sldId="258"/>
            <ac:spMk id="21" creationId="{4AC9C18D-0F9A-8E42-5219-20359771142C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23" creationId="{5EADE2B7-455B-659E-A5DD-E98F7F740DC6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24" creationId="{D28C57F8-949A-0CE2-9FDD-BF14D4E80655}"/>
          </ac:spMkLst>
        </pc:spChg>
        <pc:spChg chg="mod">
          <ac:chgData name="Bonetto, Andrea" userId="da2261fe-c884-4386-a584-05ce7944f5b0" providerId="ADAL" clId="{800AAAD2-1C14-4AF9-BF70-7299C838D77C}" dt="2025-10-24T15:06:01.887" v="1239" actId="408"/>
          <ac:spMkLst>
            <pc:docMk/>
            <pc:sldMk cId="1605436578" sldId="258"/>
            <ac:spMk id="25" creationId="{18AD6B6D-D766-DD2B-81D3-D7EBA8942E0E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26" creationId="{30002650-36DC-9655-24C2-F989230594E3}"/>
          </ac:spMkLst>
        </pc:spChg>
        <pc:spChg chg="mod topLvl">
          <ac:chgData name="Bonetto, Andrea" userId="da2261fe-c884-4386-a584-05ce7944f5b0" providerId="ADAL" clId="{800AAAD2-1C14-4AF9-BF70-7299C838D77C}" dt="2025-10-24T15:09:54.787" v="1501" actId="1036"/>
          <ac:spMkLst>
            <pc:docMk/>
            <pc:sldMk cId="1605436578" sldId="258"/>
            <ac:spMk id="27" creationId="{63D4C6AA-AC7B-57AA-6EC8-F06EA3469038}"/>
          </ac:spMkLst>
        </pc:spChg>
        <pc:spChg chg="mod">
          <ac:chgData name="Bonetto, Andrea" userId="da2261fe-c884-4386-a584-05ce7944f5b0" providerId="ADAL" clId="{800AAAD2-1C14-4AF9-BF70-7299C838D77C}" dt="2025-10-24T15:06:01.887" v="1239" actId="408"/>
          <ac:spMkLst>
            <pc:docMk/>
            <pc:sldMk cId="1605436578" sldId="258"/>
            <ac:spMk id="28" creationId="{ADDE4A51-0206-A17D-4C68-2AFC533499ED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29" creationId="{FC6F667F-24A9-F989-81D2-8B4B6448F520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30" creationId="{DAFE04D7-7A3D-6232-C077-371EE0F0AF2A}"/>
          </ac:spMkLst>
        </pc:spChg>
        <pc:spChg chg="mod topLvl">
          <ac:chgData name="Bonetto, Andrea" userId="da2261fe-c884-4386-a584-05ce7944f5b0" providerId="ADAL" clId="{800AAAD2-1C14-4AF9-BF70-7299C838D77C}" dt="2025-10-24T15:09:54.787" v="1501" actId="1036"/>
          <ac:spMkLst>
            <pc:docMk/>
            <pc:sldMk cId="1605436578" sldId="258"/>
            <ac:spMk id="31" creationId="{BBD88546-2DE1-B6FF-973B-F10DB48E1987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32" creationId="{331406D8-F4EF-BA16-A2EA-48E3446842F9}"/>
          </ac:spMkLst>
        </pc:spChg>
        <pc:spChg chg="mod topLvl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35" creationId="{EF842D2A-B76C-4E3F-6CF3-484BEE35F682}"/>
          </ac:spMkLst>
        </pc:spChg>
        <pc:spChg chg="mod topLvl">
          <ac:chgData name="Bonetto, Andrea" userId="da2261fe-c884-4386-a584-05ce7944f5b0" providerId="ADAL" clId="{800AAAD2-1C14-4AF9-BF70-7299C838D77C}" dt="2025-10-24T15:09:54.787" v="1501" actId="1036"/>
          <ac:spMkLst>
            <pc:docMk/>
            <pc:sldMk cId="1605436578" sldId="258"/>
            <ac:spMk id="36" creationId="{E4BC65DF-9A63-CFE6-5EEA-47F964AF2EFC}"/>
          </ac:spMkLst>
        </pc:spChg>
        <pc:spChg chg="add mod">
          <ac:chgData name="Bonetto, Andrea" userId="da2261fe-c884-4386-a584-05ce7944f5b0" providerId="ADAL" clId="{800AAAD2-1C14-4AF9-BF70-7299C838D77C}" dt="2025-10-24T15:09:05.370" v="1492" actId="1038"/>
          <ac:spMkLst>
            <pc:docMk/>
            <pc:sldMk cId="1605436578" sldId="258"/>
            <ac:spMk id="37" creationId="{241DB79B-11F3-A426-1F1A-27862982360E}"/>
          </ac:spMkLst>
        </pc:spChg>
        <pc:spChg chg="add mod">
          <ac:chgData name="Bonetto, Andrea" userId="da2261fe-c884-4386-a584-05ce7944f5b0" providerId="ADAL" clId="{800AAAD2-1C14-4AF9-BF70-7299C838D77C}" dt="2025-10-24T15:09:59.231" v="1509" actId="1036"/>
          <ac:spMkLst>
            <pc:docMk/>
            <pc:sldMk cId="1605436578" sldId="258"/>
            <ac:spMk id="38" creationId="{86F1BFBE-3157-F239-7828-5B5199CF505E}"/>
          </ac:spMkLst>
        </pc:spChg>
        <pc:spChg chg="add mod">
          <ac:chgData name="Bonetto, Andrea" userId="da2261fe-c884-4386-a584-05ce7944f5b0" providerId="ADAL" clId="{800AAAD2-1C14-4AF9-BF70-7299C838D77C}" dt="2025-10-24T15:09:59.231" v="1509" actId="1036"/>
          <ac:spMkLst>
            <pc:docMk/>
            <pc:sldMk cId="1605436578" sldId="258"/>
            <ac:spMk id="39" creationId="{C2A52B9D-E07F-D74F-B111-97D9E54E45CA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40" creationId="{BD075BC9-D0FD-E5B1-6147-3E18706F9ABB}"/>
          </ac:spMkLst>
        </pc:spChg>
        <pc:spChg chg="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41" creationId="{B549C87C-1F1E-6ACF-CC4D-4786F0247B8F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42" creationId="{729527DB-9C4F-D1A3-3105-93095C855022}"/>
          </ac:spMkLst>
        </pc:spChg>
        <pc:spChg chg="add mod">
          <ac:chgData name="Bonetto, Andrea" userId="da2261fe-c884-4386-a584-05ce7944f5b0" providerId="ADAL" clId="{800AAAD2-1C14-4AF9-BF70-7299C838D77C}" dt="2025-10-24T15:09:59.231" v="1509" actId="1036"/>
          <ac:spMkLst>
            <pc:docMk/>
            <pc:sldMk cId="1605436578" sldId="258"/>
            <ac:spMk id="43" creationId="{33450712-5D9E-7C83-9DDB-CC30BC7BFC33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45" creationId="{F4F2D908-2098-D925-A6B7-3BD0FFA65E2A}"/>
          </ac:spMkLst>
        </pc:spChg>
        <pc:spChg chg="add mod">
          <ac:chgData name="Bonetto, Andrea" userId="da2261fe-c884-4386-a584-05ce7944f5b0" providerId="ADAL" clId="{800AAAD2-1C14-4AF9-BF70-7299C838D77C}" dt="2025-10-24T15:09:59.231" v="1509" actId="1036"/>
          <ac:spMkLst>
            <pc:docMk/>
            <pc:sldMk cId="1605436578" sldId="258"/>
            <ac:spMk id="46" creationId="{DBC39E7B-BE11-FC61-60D0-39F6CE8C060B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47" creationId="{4456EA84-C8CC-C0A8-50CA-33B7934C1F3B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50" creationId="{CBE870E9-9639-39AD-EE23-385886A33CF8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51" creationId="{E0FBAFEF-48CB-AB42-68FB-1019D9007361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53" creationId="{A8DECB1E-5525-0902-9C21-6C89EFD64346}"/>
          </ac:spMkLst>
        </pc:spChg>
        <pc:spChg chg="add mod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54" creationId="{B81CA2EC-4C43-9C58-AEDE-94ACFB12BD7E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55" creationId="{7EB18C72-0D43-6E29-6435-C06BD5D2C106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56" creationId="{4D3A1CCF-27D8-F7D5-C0B1-F4882A206F06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57" creationId="{324E7114-067E-59BA-5DCC-6E80176FD206}"/>
          </ac:spMkLst>
        </pc:spChg>
        <pc:spChg chg="add mod">
          <ac:chgData name="Bonetto, Andrea" userId="da2261fe-c884-4386-a584-05ce7944f5b0" providerId="ADAL" clId="{800AAAD2-1C14-4AF9-BF70-7299C838D77C}" dt="2025-10-24T15:49:51.209" v="2825" actId="164"/>
          <ac:spMkLst>
            <pc:docMk/>
            <pc:sldMk cId="1605436578" sldId="258"/>
            <ac:spMk id="58" creationId="{AE0B6BEA-83BF-B22A-1C30-85DD845026C9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59" creationId="{264BCDE3-2B69-1E2B-9AB1-C3B6A5D37AB8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60" creationId="{94660A85-C960-219F-615B-0B15E42E9E97}"/>
          </ac:spMkLst>
        </pc:spChg>
        <pc:spChg chg="add mod">
          <ac:chgData name="Bonetto, Andrea" userId="da2261fe-c884-4386-a584-05ce7944f5b0" providerId="ADAL" clId="{800AAAD2-1C14-4AF9-BF70-7299C838D77C}" dt="2025-10-24T15:43:42.188" v="2629" actId="553"/>
          <ac:spMkLst>
            <pc:docMk/>
            <pc:sldMk cId="1605436578" sldId="258"/>
            <ac:spMk id="61" creationId="{0317BF73-1272-AFA5-F380-B1DD8E31EAE7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2" creationId="{FE9AA566-B376-6AC4-B81C-EC633815A882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3" creationId="{A6ACBE1F-456F-E0A1-2047-7695157D2617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4" creationId="{49CC4103-164D-91F0-A2A3-FC3AFB9C4D68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5" creationId="{44E820BD-D57A-061D-2116-CE1E60E1A2C4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6" creationId="{A4DC1530-EBD1-97FD-7EE9-6E6ECB8AEBA8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7" creationId="{F37F7AEC-BBF6-01B1-1732-E8706B53DB1B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8" creationId="{66D7D19B-B80A-0FA8-33DE-B47C984809DD}"/>
          </ac:spMkLst>
        </pc:spChg>
        <pc:spChg chg="add del mod">
          <ac:chgData name="Bonetto, Andrea" userId="da2261fe-c884-4386-a584-05ce7944f5b0" providerId="ADAL" clId="{800AAAD2-1C14-4AF9-BF70-7299C838D77C}" dt="2025-10-24T15:49:04.779" v="2788" actId="478"/>
          <ac:spMkLst>
            <pc:docMk/>
            <pc:sldMk cId="1605436578" sldId="258"/>
            <ac:spMk id="69" creationId="{32D45D65-9C43-B1CF-16AB-F1D02FE71C98}"/>
          </ac:spMkLst>
        </pc:spChg>
        <pc:spChg chg="add del mod">
          <ac:chgData name="Bonetto, Andrea" userId="da2261fe-c884-4386-a584-05ce7944f5b0" providerId="ADAL" clId="{800AAAD2-1C14-4AF9-BF70-7299C838D77C}" dt="2025-10-24T15:47:02.763" v="2740" actId="478"/>
          <ac:spMkLst>
            <pc:docMk/>
            <pc:sldMk cId="1605436578" sldId="258"/>
            <ac:spMk id="70" creationId="{49683B75-7980-67AF-D2A2-A5ADDEEBBFEC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72" creationId="{80146406-BCB0-6203-A07E-E115560BB6A7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73" creationId="{EDECB806-74EE-9DBB-1AFA-3C1293835196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74" creationId="{7DC69982-62DE-44C4-19C7-31AE729EB2B4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75" creationId="{187F054F-CF6D-DD84-8CC5-5F3F53D13962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76" creationId="{DB5C3177-01F4-9371-626F-6D2B40507638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77" creationId="{C81600A9-470B-EB6A-B838-540D8904194D}"/>
          </ac:spMkLst>
        </pc:spChg>
        <pc:spChg chg="add mod">
          <ac:chgData name="Bonetto, Andrea" userId="da2261fe-c884-4386-a584-05ce7944f5b0" providerId="ADAL" clId="{800AAAD2-1C14-4AF9-BF70-7299C838D77C}" dt="2025-10-24T15:49:43.337" v="2804" actId="164"/>
          <ac:spMkLst>
            <pc:docMk/>
            <pc:sldMk cId="1605436578" sldId="258"/>
            <ac:spMk id="78" creationId="{2636ED85-88B7-02E4-C197-49E88C83B788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79" creationId="{D23BAAF9-7819-F70A-9752-5B706B6A8BC1}"/>
          </ac:spMkLst>
        </pc:spChg>
        <pc:spChg chg="add mod">
          <ac:chgData name="Bonetto, Andrea" userId="da2261fe-c884-4386-a584-05ce7944f5b0" providerId="ADAL" clId="{800AAAD2-1C14-4AF9-BF70-7299C838D77C}" dt="2025-10-24T15:49:27.053" v="2803" actId="1035"/>
          <ac:spMkLst>
            <pc:docMk/>
            <pc:sldMk cId="1605436578" sldId="258"/>
            <ac:spMk id="80" creationId="{B0667C62-78AC-AA4A-85B5-7BCD678B44D2}"/>
          </ac:spMkLst>
        </pc:spChg>
        <pc:grpChg chg="del">
          <ac:chgData name="Bonetto, Andrea" userId="da2261fe-c884-4386-a584-05ce7944f5b0" providerId="ADAL" clId="{800AAAD2-1C14-4AF9-BF70-7299C838D77C}" dt="2025-10-24T15:04:53.655" v="1189" actId="165"/>
          <ac:grpSpMkLst>
            <pc:docMk/>
            <pc:sldMk cId="1605436578" sldId="258"/>
            <ac:grpSpMk id="16" creationId="{70E3BCB3-C80E-6B00-F722-F3AC3F3D799B}"/>
          </ac:grpSpMkLst>
        </pc:grpChg>
        <pc:grpChg chg="mod">
          <ac:chgData name="Bonetto, Andrea" userId="da2261fe-c884-4386-a584-05ce7944f5b0" providerId="ADAL" clId="{800AAAD2-1C14-4AF9-BF70-7299C838D77C}" dt="2025-10-24T15:05:37.646" v="1199" actId="1076"/>
          <ac:grpSpMkLst>
            <pc:docMk/>
            <pc:sldMk cId="1605436578" sldId="258"/>
            <ac:grpSpMk id="22" creationId="{27BE3E0C-5AF6-2C6D-3923-4F19CF314D71}"/>
          </ac:grpSpMkLst>
        </pc:grpChg>
        <pc:grpChg chg="add del mod">
          <ac:chgData name="Bonetto, Andrea" userId="da2261fe-c884-4386-a584-05ce7944f5b0" providerId="ADAL" clId="{800AAAD2-1C14-4AF9-BF70-7299C838D77C}" dt="2025-10-24T15:48:41.803" v="2776" actId="478"/>
          <ac:grpSpMkLst>
            <pc:docMk/>
            <pc:sldMk cId="1605436578" sldId="258"/>
            <ac:grpSpMk id="52" creationId="{B38F2934-FAE3-8902-D1ED-27C1A3A362AE}"/>
          </ac:grpSpMkLst>
        </pc:grpChg>
        <pc:grpChg chg="mod">
          <ac:chgData name="Bonetto, Andrea" userId="da2261fe-c884-4386-a584-05ce7944f5b0" providerId="ADAL" clId="{800AAAD2-1C14-4AF9-BF70-7299C838D77C}" dt="2025-10-24T15:51:39.104" v="2914" actId="164"/>
          <ac:grpSpMkLst>
            <pc:docMk/>
            <pc:sldMk cId="1605436578" sldId="258"/>
            <ac:grpSpMk id="81" creationId="{23A10433-BDB2-A66B-8772-BABC7E46EBD8}"/>
          </ac:grpSpMkLst>
        </pc:grpChg>
        <pc:grpChg chg="mod">
          <ac:chgData name="Bonetto, Andrea" userId="da2261fe-c884-4386-a584-05ce7944f5b0" providerId="ADAL" clId="{800AAAD2-1C14-4AF9-BF70-7299C838D77C}" dt="2025-10-24T15:51:39.104" v="2914" actId="164"/>
          <ac:grpSpMkLst>
            <pc:docMk/>
            <pc:sldMk cId="1605436578" sldId="258"/>
            <ac:grpSpMk id="82" creationId="{086826CA-886D-D22D-2D53-47488F3E2015}"/>
          </ac:grpSpMkLst>
        </pc:grpChg>
        <pc:grpChg chg="add mod">
          <ac:chgData name="Bonetto, Andrea" userId="da2261fe-c884-4386-a584-05ce7944f5b0" providerId="ADAL" clId="{800AAAD2-1C14-4AF9-BF70-7299C838D77C}" dt="2025-10-24T15:51:43.657" v="2931" actId="1036"/>
          <ac:grpSpMkLst>
            <pc:docMk/>
            <pc:sldMk cId="1605436578" sldId="258"/>
            <ac:grpSpMk id="83" creationId="{39301599-6B33-C6C2-ADDB-D76949531D12}"/>
          </ac:grpSpMkLst>
        </pc:grpChg>
        <pc:picChg chg="del mod topLvl">
          <ac:chgData name="Bonetto, Andrea" userId="da2261fe-c884-4386-a584-05ce7944f5b0" providerId="ADAL" clId="{800AAAD2-1C14-4AF9-BF70-7299C838D77C}" dt="2025-10-24T15:48:41.803" v="2776" actId="478"/>
          <ac:picMkLst>
            <pc:docMk/>
            <pc:sldMk cId="1605436578" sldId="258"/>
            <ac:picMk id="4" creationId="{8C522DED-7292-940A-6BE5-6FEA666D398B}"/>
          </ac:picMkLst>
        </pc:picChg>
        <pc:picChg chg="mod topLvl">
          <ac:chgData name="Bonetto, Andrea" userId="da2261fe-c884-4386-a584-05ce7944f5b0" providerId="ADAL" clId="{800AAAD2-1C14-4AF9-BF70-7299C838D77C}" dt="2025-10-24T15:05:21.018" v="1195" actId="1076"/>
          <ac:picMkLst>
            <pc:docMk/>
            <pc:sldMk cId="1605436578" sldId="258"/>
            <ac:picMk id="5" creationId="{53A5F2F4-6DD3-0B05-52EC-4602F2E0E9BC}"/>
          </ac:picMkLst>
        </pc:picChg>
        <pc:picChg chg="add mod ord">
          <ac:chgData name="Bonetto, Andrea" userId="da2261fe-c884-4386-a584-05ce7944f5b0" providerId="ADAL" clId="{800AAAD2-1C14-4AF9-BF70-7299C838D77C}" dt="2025-10-24T15:48:54.790" v="2782" actId="1035"/>
          <ac:picMkLst>
            <pc:docMk/>
            <pc:sldMk cId="1605436578" sldId="258"/>
            <ac:picMk id="71" creationId="{0202EC82-B368-A526-9967-161B25204593}"/>
          </ac:picMkLst>
        </pc:picChg>
        <pc:cxnChg chg="del">
          <ac:chgData name="Bonetto, Andrea" userId="da2261fe-c884-4386-a584-05ce7944f5b0" providerId="ADAL" clId="{800AAAD2-1C14-4AF9-BF70-7299C838D77C}" dt="2025-10-24T15:05:30.705" v="1196" actId="478"/>
          <ac:cxnSpMkLst>
            <pc:docMk/>
            <pc:sldMk cId="1605436578" sldId="258"/>
            <ac:cxnSpMk id="10" creationId="{E2410866-0EB7-CC4D-8AFB-31538863108A}"/>
          </ac:cxnSpMkLst>
        </pc:cxnChg>
        <pc:cxnChg chg="del mod topLvl">
          <ac:chgData name="Bonetto, Andrea" userId="da2261fe-c884-4386-a584-05ce7944f5b0" providerId="ADAL" clId="{800AAAD2-1C14-4AF9-BF70-7299C838D77C}" dt="2025-10-24T15:05:30.705" v="1196" actId="478"/>
          <ac:cxnSpMkLst>
            <pc:docMk/>
            <pc:sldMk cId="1605436578" sldId="258"/>
            <ac:cxnSpMk id="11" creationId="{E5D541A3-DA01-899C-16D0-0481B2823F72}"/>
          </ac:cxnSpMkLst>
        </pc:cxnChg>
        <pc:cxnChg chg="del">
          <ac:chgData name="Bonetto, Andrea" userId="da2261fe-c884-4386-a584-05ce7944f5b0" providerId="ADAL" clId="{800AAAD2-1C14-4AF9-BF70-7299C838D77C}" dt="2025-10-24T15:05:32.517" v="1197" actId="478"/>
          <ac:cxnSpMkLst>
            <pc:docMk/>
            <pc:sldMk cId="1605436578" sldId="258"/>
            <ac:cxnSpMk id="14" creationId="{EB0A8C5F-2A41-9C00-E049-058DD63AE473}"/>
          </ac:cxnSpMkLst>
        </pc:cxnChg>
        <pc:cxnChg chg="del">
          <ac:chgData name="Bonetto, Andrea" userId="da2261fe-c884-4386-a584-05ce7944f5b0" providerId="ADAL" clId="{800AAAD2-1C14-4AF9-BF70-7299C838D77C}" dt="2025-10-24T15:05:32.517" v="1197" actId="478"/>
          <ac:cxnSpMkLst>
            <pc:docMk/>
            <pc:sldMk cId="1605436578" sldId="258"/>
            <ac:cxnSpMk id="15" creationId="{96374181-A5B0-67BD-532C-77FBAC3A2B1B}"/>
          </ac:cxnSpMkLst>
        </pc:cxnChg>
        <pc:cxnChg chg="mod">
          <ac:chgData name="Bonetto, Andrea" userId="da2261fe-c884-4386-a584-05ce7944f5b0" providerId="ADAL" clId="{800AAAD2-1C14-4AF9-BF70-7299C838D77C}" dt="2025-10-24T15:06:32.877" v="1296" actId="14100"/>
          <ac:cxnSpMkLst>
            <pc:docMk/>
            <pc:sldMk cId="1605436578" sldId="258"/>
            <ac:cxnSpMk id="33" creationId="{3976B069-65ED-3CD8-41FB-BFE7E7CBEEFC}"/>
          </ac:cxnSpMkLst>
        </pc:cxnChg>
        <pc:cxnChg chg="mod">
          <ac:chgData name="Bonetto, Andrea" userId="da2261fe-c884-4386-a584-05ce7944f5b0" providerId="ADAL" clId="{800AAAD2-1C14-4AF9-BF70-7299C838D77C}" dt="2025-10-24T15:06:46.387" v="1318" actId="1037"/>
          <ac:cxnSpMkLst>
            <pc:docMk/>
            <pc:sldMk cId="1605436578" sldId="258"/>
            <ac:cxnSpMk id="34" creationId="{61A55C65-A736-DF63-340E-33C183601B2D}"/>
          </ac:cxnSpMkLst>
        </pc:cxnChg>
      </pc:sldChg>
      <pc:sldChg chg="delSp new del mod">
        <pc:chgData name="Bonetto, Andrea" userId="da2261fe-c884-4386-a584-05ce7944f5b0" providerId="ADAL" clId="{800AAAD2-1C14-4AF9-BF70-7299C838D77C}" dt="2025-10-08T19:47:37.974" v="431" actId="47"/>
        <pc:sldMkLst>
          <pc:docMk/>
          <pc:sldMk cId="57911502" sldId="259"/>
        </pc:sldMkLst>
      </pc:sldChg>
      <pc:sldChg chg="addSp delSp modSp new mod">
        <pc:chgData name="Bonetto, Andrea" userId="da2261fe-c884-4386-a584-05ce7944f5b0" providerId="ADAL" clId="{800AAAD2-1C14-4AF9-BF70-7299C838D77C}" dt="2025-10-24T15:51:30.445" v="2913" actId="1036"/>
        <pc:sldMkLst>
          <pc:docMk/>
          <pc:sldMk cId="124269244" sldId="259"/>
        </pc:sldMkLst>
        <pc:spChg chg="del">
          <ac:chgData name="Bonetto, Andrea" userId="da2261fe-c884-4386-a584-05ce7944f5b0" providerId="ADAL" clId="{800AAAD2-1C14-4AF9-BF70-7299C838D77C}" dt="2025-10-24T14:51:55.249" v="613" actId="478"/>
          <ac:spMkLst>
            <pc:docMk/>
            <pc:sldMk cId="124269244" sldId="259"/>
            <ac:spMk id="2" creationId="{8DCBC738-B1A8-E111-5463-93D18FF6FE38}"/>
          </ac:spMkLst>
        </pc:spChg>
        <pc:spChg chg="del">
          <ac:chgData name="Bonetto, Andrea" userId="da2261fe-c884-4386-a584-05ce7944f5b0" providerId="ADAL" clId="{800AAAD2-1C14-4AF9-BF70-7299C838D77C}" dt="2025-10-24T14:51:56.353" v="614" actId="478"/>
          <ac:spMkLst>
            <pc:docMk/>
            <pc:sldMk cId="124269244" sldId="259"/>
            <ac:spMk id="3" creationId="{3D1808C9-35B2-5F33-39DF-6C3968286B83}"/>
          </ac:spMkLst>
        </pc:spChg>
        <pc:spChg chg="mod">
          <ac:chgData name="Bonetto, Andrea" userId="da2261fe-c884-4386-a584-05ce7944f5b0" providerId="ADAL" clId="{800AAAD2-1C14-4AF9-BF70-7299C838D77C}" dt="2025-10-24T15:02:45.241" v="1126" actId="408"/>
          <ac:spMkLst>
            <pc:docMk/>
            <pc:sldMk cId="124269244" sldId="259"/>
            <ac:spMk id="6" creationId="{C3C08E02-5D70-DE02-1A17-C7F93E30DF5C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7" creationId="{6F347BBE-164E-2907-0A04-EF37B9A8197B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8" creationId="{CB8B517E-FFF4-FE15-7118-E642ADB44E91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9" creationId="{9E054685-1914-3628-DD11-3F2CC2AA9784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10" creationId="{0DB22760-DD03-9143-9917-CCAE91D874D3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12" creationId="{9C9F2753-FD05-EC7D-48B4-4D488AB38334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14" creationId="{65C49E7A-33D1-B6BE-B526-F81B66EE86DD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15" creationId="{821D85DE-274D-FCC0-22C7-5E4258BBEE7C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16" creationId="{FF89F6CC-5EF0-4422-C006-225AE2657AC3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17" creationId="{9E4A1FE3-7D4E-FDAF-EABA-8CA27867162B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18" creationId="{E1600440-F114-BA0A-048B-715D8030834A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19" creationId="{3B233A91-1098-7E7E-BB33-9E5130EDEF8B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20" creationId="{E0654FCF-545C-4F10-5450-298150A188F8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23" creationId="{F2CA22B2-9E8B-02FF-AA5F-70B40895E510}"/>
          </ac:spMkLst>
        </pc:spChg>
        <pc:spChg chg="mod topLvl">
          <ac:chgData name="Bonetto, Andrea" userId="da2261fe-c884-4386-a584-05ce7944f5b0" providerId="ADAL" clId="{800AAAD2-1C14-4AF9-BF70-7299C838D77C}" dt="2025-10-24T15:03:31.439" v="1144" actId="164"/>
          <ac:spMkLst>
            <pc:docMk/>
            <pc:sldMk cId="124269244" sldId="259"/>
            <ac:spMk id="24" creationId="{5A3D89C9-753B-68AF-4603-DD8DD2003BC4}"/>
          </ac:spMkLst>
        </pc:spChg>
        <pc:spChg chg="add del mod">
          <ac:chgData name="Bonetto, Andrea" userId="da2261fe-c884-4386-a584-05ce7944f5b0" providerId="ADAL" clId="{800AAAD2-1C14-4AF9-BF70-7299C838D77C}" dt="2025-10-24T15:01:22.952" v="1004" actId="478"/>
          <ac:spMkLst>
            <pc:docMk/>
            <pc:sldMk cId="124269244" sldId="259"/>
            <ac:spMk id="25" creationId="{270E2B1F-4621-251A-3D59-5BF031AA91AE}"/>
          </ac:spMkLst>
        </pc:spChg>
        <pc:spChg chg="add del mod">
          <ac:chgData name="Bonetto, Andrea" userId="da2261fe-c884-4386-a584-05ce7944f5b0" providerId="ADAL" clId="{800AAAD2-1C14-4AF9-BF70-7299C838D77C}" dt="2025-10-24T15:01:24.632" v="1005" actId="478"/>
          <ac:spMkLst>
            <pc:docMk/>
            <pc:sldMk cId="124269244" sldId="259"/>
            <ac:spMk id="26" creationId="{CB328EBC-88C9-2DAF-A43C-26126A599213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1" creationId="{28833F6C-2643-ED70-D15E-209F21A0160D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2" creationId="{13360A53-E354-47A4-4384-AAA9D4D5E294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5" creationId="{83ED9C10-DF9C-C215-3B19-ABCC3D6039D7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6" creationId="{3315730D-537F-CCE9-1FB0-496BB2059A48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7" creationId="{0DA0EE26-5D1C-9E7D-1A0D-89048A0AC88E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8" creationId="{6D508167-4CD1-6D9C-E262-0E021A26C67B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39" creationId="{D9CA2868-663F-97C6-37D0-E3F594159FCD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40" creationId="{52B0849D-8039-0258-A2F9-ED0B80725CD6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43" creationId="{760E3DDE-D174-D3D0-2DBD-CF0AD1CF67D1}"/>
          </ac:spMkLst>
        </pc:spChg>
        <pc:spChg chg="mod">
          <ac:chgData name="Bonetto, Andrea" userId="da2261fe-c884-4386-a584-05ce7944f5b0" providerId="ADAL" clId="{800AAAD2-1C14-4AF9-BF70-7299C838D77C}" dt="2025-10-24T15:03:32.698" v="1145"/>
          <ac:spMkLst>
            <pc:docMk/>
            <pc:sldMk cId="124269244" sldId="259"/>
            <ac:spMk id="44" creationId="{F6F6CF06-CD8D-D0CA-0DB7-A50266F93C67}"/>
          </ac:spMkLst>
        </pc:spChg>
        <pc:spChg chg="add mod">
          <ac:chgData name="Bonetto, Andrea" userId="da2261fe-c884-4386-a584-05ce7944f5b0" providerId="ADAL" clId="{800AAAD2-1C14-4AF9-BF70-7299C838D77C}" dt="2025-10-24T15:04:40.744" v="1186"/>
          <ac:spMkLst>
            <pc:docMk/>
            <pc:sldMk cId="124269244" sldId="259"/>
            <ac:spMk id="45" creationId="{EB44D22F-85D0-3C57-9162-B08A345C7D27}"/>
          </ac:spMkLst>
        </pc:spChg>
        <pc:spChg chg="add del mod">
          <ac:chgData name="Bonetto, Andrea" userId="da2261fe-c884-4386-a584-05ce7944f5b0" providerId="ADAL" clId="{800AAAD2-1C14-4AF9-BF70-7299C838D77C}" dt="2025-10-24T15:40:05.322" v="2056" actId="478"/>
          <ac:spMkLst>
            <pc:docMk/>
            <pc:sldMk cId="124269244" sldId="259"/>
            <ac:spMk id="46" creationId="{D94FFB15-890A-7C14-EE34-E3583FEE97E9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47" creationId="{EB901349-83B4-6553-227D-59547FD756A0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48" creationId="{053BC0B5-F003-DE44-244C-E294EBCB8762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49" creationId="{FB4F6C3F-0357-39A6-49E2-718BAE55E654}"/>
          </ac:spMkLst>
        </pc:spChg>
        <pc:spChg chg="add mod">
          <ac:chgData name="Bonetto, Andrea" userId="da2261fe-c884-4386-a584-05ce7944f5b0" providerId="ADAL" clId="{800AAAD2-1C14-4AF9-BF70-7299C838D77C}" dt="2025-10-24T15:50:11.482" v="2858" actId="164"/>
          <ac:spMkLst>
            <pc:docMk/>
            <pc:sldMk cId="124269244" sldId="259"/>
            <ac:spMk id="50" creationId="{CCD2968E-DC33-9E18-C5D8-2500D7D06068}"/>
          </ac:spMkLst>
        </pc:spChg>
        <pc:spChg chg="add del mod">
          <ac:chgData name="Bonetto, Andrea" userId="da2261fe-c884-4386-a584-05ce7944f5b0" providerId="ADAL" clId="{800AAAD2-1C14-4AF9-BF70-7299C838D77C}" dt="2025-10-24T15:41:21.281" v="2142" actId="478"/>
          <ac:spMkLst>
            <pc:docMk/>
            <pc:sldMk cId="124269244" sldId="259"/>
            <ac:spMk id="51" creationId="{D20BD0FE-2E53-C1EC-1CFE-A92F5E01491A}"/>
          </ac:spMkLst>
        </pc:spChg>
        <pc:spChg chg="add del mod">
          <ac:chgData name="Bonetto, Andrea" userId="da2261fe-c884-4386-a584-05ce7944f5b0" providerId="ADAL" clId="{800AAAD2-1C14-4AF9-BF70-7299C838D77C}" dt="2025-10-24T15:41:28.530" v="2160" actId="478"/>
          <ac:spMkLst>
            <pc:docMk/>
            <pc:sldMk cId="124269244" sldId="259"/>
            <ac:spMk id="52" creationId="{7759E455-3B24-03CB-7089-B98E0F571D9F}"/>
          </ac:spMkLst>
        </pc:spChg>
        <pc:spChg chg="add del mod">
          <ac:chgData name="Bonetto, Andrea" userId="da2261fe-c884-4386-a584-05ce7944f5b0" providerId="ADAL" clId="{800AAAD2-1C14-4AF9-BF70-7299C838D77C}" dt="2025-10-24T15:40:05.322" v="2056" actId="478"/>
          <ac:spMkLst>
            <pc:docMk/>
            <pc:sldMk cId="124269244" sldId="259"/>
            <ac:spMk id="53" creationId="{715763CA-A7AC-8CEB-167E-ACD4D0A56094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54" creationId="{F9B8BA50-2BA4-4555-E2B5-999CEC7CA315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55" creationId="{CB3B1192-AE0D-4A49-5C3A-55EE4D5F820F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56" creationId="{0F10022F-8FEA-9ECD-6FB0-98B4005A9A61}"/>
          </ac:spMkLst>
        </pc:spChg>
        <pc:spChg chg="add mod">
          <ac:chgData name="Bonetto, Andrea" userId="da2261fe-c884-4386-a584-05ce7944f5b0" providerId="ADAL" clId="{800AAAD2-1C14-4AF9-BF70-7299C838D77C}" dt="2025-10-24T15:50:03.671" v="2840" actId="164"/>
          <ac:spMkLst>
            <pc:docMk/>
            <pc:sldMk cId="124269244" sldId="259"/>
            <ac:spMk id="57" creationId="{8D7822ED-9DC8-2F59-1671-17369A04CDAB}"/>
          </ac:spMkLst>
        </pc:spChg>
        <pc:grpChg chg="mod">
          <ac:chgData name="Bonetto, Andrea" userId="da2261fe-c884-4386-a584-05ce7944f5b0" providerId="ADAL" clId="{800AAAD2-1C14-4AF9-BF70-7299C838D77C}" dt="2025-10-24T15:50:11.482" v="2858" actId="164"/>
          <ac:grpSpMkLst>
            <pc:docMk/>
            <pc:sldMk cId="124269244" sldId="259"/>
            <ac:grpSpMk id="29" creationId="{67776C66-231C-5983-CB59-C13635FFC752}"/>
          </ac:grpSpMkLst>
        </pc:grpChg>
        <pc:grpChg chg="mod">
          <ac:chgData name="Bonetto, Andrea" userId="da2261fe-c884-4386-a584-05ce7944f5b0" providerId="ADAL" clId="{800AAAD2-1C14-4AF9-BF70-7299C838D77C}" dt="2025-10-24T15:50:03.671" v="2840" actId="164"/>
          <ac:grpSpMkLst>
            <pc:docMk/>
            <pc:sldMk cId="124269244" sldId="259"/>
            <ac:grpSpMk id="30" creationId="{697FAD5A-267E-F7B7-56B9-B8526F44472A}"/>
          </ac:grpSpMkLst>
        </pc:grpChg>
        <pc:grpChg chg="add mod">
          <ac:chgData name="Bonetto, Andrea" userId="da2261fe-c884-4386-a584-05ce7944f5b0" providerId="ADAL" clId="{800AAAD2-1C14-4AF9-BF70-7299C838D77C}" dt="2025-10-24T15:51:25.790" v="2901" actId="164"/>
          <ac:grpSpMkLst>
            <pc:docMk/>
            <pc:sldMk cId="124269244" sldId="259"/>
            <ac:grpSpMk id="58" creationId="{29733D15-510E-23D3-EC73-4BC70288E59F}"/>
          </ac:grpSpMkLst>
        </pc:grpChg>
        <pc:grpChg chg="add mod">
          <ac:chgData name="Bonetto, Andrea" userId="da2261fe-c884-4386-a584-05ce7944f5b0" providerId="ADAL" clId="{800AAAD2-1C14-4AF9-BF70-7299C838D77C}" dt="2025-10-24T15:51:25.790" v="2901" actId="164"/>
          <ac:grpSpMkLst>
            <pc:docMk/>
            <pc:sldMk cId="124269244" sldId="259"/>
            <ac:grpSpMk id="59" creationId="{6240E221-5927-7E2F-D583-5CDA85269A13}"/>
          </ac:grpSpMkLst>
        </pc:grpChg>
        <pc:grpChg chg="add mod">
          <ac:chgData name="Bonetto, Andrea" userId="da2261fe-c884-4386-a584-05ce7944f5b0" providerId="ADAL" clId="{800AAAD2-1C14-4AF9-BF70-7299C838D77C}" dt="2025-10-24T15:51:30.445" v="2913" actId="1036"/>
          <ac:grpSpMkLst>
            <pc:docMk/>
            <pc:sldMk cId="124269244" sldId="259"/>
            <ac:grpSpMk id="60" creationId="{F467793D-AFC5-6655-6E39-20A259DB1B6F}"/>
          </ac:grpSpMkLst>
        </pc:grpChg>
        <pc:picChg chg="add mod modCrop">
          <ac:chgData name="Bonetto, Andrea" userId="da2261fe-c884-4386-a584-05ce7944f5b0" providerId="ADAL" clId="{800AAAD2-1C14-4AF9-BF70-7299C838D77C}" dt="2025-10-24T15:50:11.482" v="2858" actId="164"/>
          <ac:picMkLst>
            <pc:docMk/>
            <pc:sldMk cId="124269244" sldId="259"/>
            <ac:picMk id="11" creationId="{2B8392D5-352B-A279-542B-91B284E2931C}"/>
          </ac:picMkLst>
        </pc:picChg>
        <pc:picChg chg="add mod modCrop">
          <ac:chgData name="Bonetto, Andrea" userId="da2261fe-c884-4386-a584-05ce7944f5b0" providerId="ADAL" clId="{800AAAD2-1C14-4AF9-BF70-7299C838D77C}" dt="2025-10-24T15:50:03.671" v="2840" actId="164"/>
          <ac:picMkLst>
            <pc:docMk/>
            <pc:sldMk cId="124269244" sldId="259"/>
            <ac:picMk id="13" creationId="{142EC758-12BC-2E5D-E2C0-BDEE0F844442}"/>
          </ac:picMkLst>
        </pc:picChg>
        <pc:cxnChg chg="mod">
          <ac:chgData name="Bonetto, Andrea" userId="da2261fe-c884-4386-a584-05ce7944f5b0" providerId="ADAL" clId="{800AAAD2-1C14-4AF9-BF70-7299C838D77C}" dt="2025-10-24T15:03:01.034" v="1129" actId="14100"/>
          <ac:cxnSpMkLst>
            <pc:docMk/>
            <pc:sldMk cId="124269244" sldId="259"/>
            <ac:cxnSpMk id="21" creationId="{85787BD7-EF07-6754-FC9F-4CE57C7EE779}"/>
          </ac:cxnSpMkLst>
        </pc:cxnChg>
        <pc:cxnChg chg="mod">
          <ac:chgData name="Bonetto, Andrea" userId="da2261fe-c884-4386-a584-05ce7944f5b0" providerId="ADAL" clId="{800AAAD2-1C14-4AF9-BF70-7299C838D77C}" dt="2025-10-24T15:03:12.057" v="1143" actId="1037"/>
          <ac:cxnSpMkLst>
            <pc:docMk/>
            <pc:sldMk cId="124269244" sldId="259"/>
            <ac:cxnSpMk id="22" creationId="{70FB7796-00F9-F1B0-19A7-F33D22982BE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796CF-1803-78DA-AB96-21AE0FCCE1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233E60-E333-EF3C-3DA1-5079D8CFF5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8F46E-49C6-A654-433E-2AEC27CDC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DEA52C-37D6-DF81-AD41-0960DE3AC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28B5BC-253D-124F-AF1E-B8D12F3BF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11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770FD-65EE-DC77-ABD1-94CD8C4F0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F8FD03-0817-8D8E-1531-1801B1D711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259C7-CBAC-7DFF-9C2F-AA42C532C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67499-05E5-583E-3A90-0D43D7EA0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5663C-FE61-61DB-6FFB-DBBD19B11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048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636031-0496-1EDF-D8D3-2DD9A90FB2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5F4E7B-43B8-28AD-916E-9241907A08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C890B4-E784-76E2-C34E-CC8D92A20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78AD54-2B49-5C2E-B290-795E542DB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3517F1-BBEC-1A52-97AB-374004F23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334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711C3-3727-3E85-7DD1-9A4454CF4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64AB3F-61C6-9D74-EB79-9DAEB7FDD3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AD051-B6B2-6FF9-EBC3-1878B52F2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38151B-3F45-CA4E-6BEC-ED0AC8D92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B3C974-35A4-4153-4B8A-A9C5831AC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730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09920-9F34-30E2-04F6-C350A6E7B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44FE0A-CA25-1362-3A6E-23060F4D5D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15E498-0F39-80A7-1500-EBB30CAF9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426DF-256E-8BE8-A2C5-48B7E41F6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F9EC3-4473-565C-D9B7-C053FA1F9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18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B2569-5699-CF32-DA55-843E2835EF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602774-2FB4-D8EF-73AA-D1AD7BAD11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51BCFA-41A1-93D0-A94B-AFF1D9ED0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C71096-6252-F400-2C11-E8BBC744B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1C275-B589-0622-E9DB-9C84FE9A7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CBDD10-5F05-0B6E-4D7E-4CFE876FD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35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89B96-A600-FF94-5790-826772E74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E8E405-19FA-0C5E-2CEB-7E283BC089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D0D7FD-8F33-A3C2-B565-3FA122DCC7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D94FC7-E1AD-F473-80DA-2EA91DEB13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E420FA-7C55-CD58-1A09-32F9545877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910B94-0E55-8E21-B9DD-7473BC5AA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901D1-9962-4FBC-894D-D75CAFF71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C0AEBB-BC0C-F928-C7C5-C29B11091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299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BDF4B-C8EB-51C5-36B4-4A8B1FD22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13FC07-F5B5-617F-980E-97C850F9E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90C9A1-3504-1907-B7C7-4F2F7DA98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E47D71-7683-1FD7-84E5-A9B05E414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961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E6BF50-9A00-9E9E-7A4C-1579106B3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36A0BA-E4D7-83B8-D84B-71FA77D9B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6D3F47-6744-8344-B45A-3ACA3F6DE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267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489AB1-BE6A-07DC-96B8-5D2DCEE79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769B18-D291-A203-4F86-FA76E2F69F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4C4E54-32CC-49BE-14E1-026935F7EE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039A0-C181-7144-63E4-684982180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964751-5A56-E13D-D848-4D3F1CF11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69B83F-41A4-3F24-FD97-1ADA31D03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299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833B5A-FEE3-D509-9EBE-9C500C31D2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9CECD5-D2D6-90AF-36E5-5B766484CE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BB28A4-E47F-F03E-2FA3-0F1B375C4C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AE9E17-79B6-A5E1-C792-F25993BED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4128BC-B5EC-6AC3-309D-2BEC938C2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B8F637-B80C-4CBC-693B-D84E959BD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51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3AD647-06E6-EA1C-8684-0E072F6AC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5DF75E-A337-9DA4-4467-755BF378C6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B2AD1-625A-07E2-F6FD-FA9EF47678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16F085-7108-4969-B4FB-2FD54CFB7857}" type="datetimeFigureOut">
              <a:rPr lang="en-US" smtClean="0"/>
              <a:t>10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46B597-215C-ACF5-466F-C099A63744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6FC85D-8746-A44D-8773-E88ED5C3BB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EA138A-D415-42AC-B288-D1E0EEF70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443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20BC326-F297-D4E9-8BC7-681AC0DCDE66}"/>
              </a:ext>
            </a:extLst>
          </p:cNvPr>
          <p:cNvSpPr txBox="1"/>
          <p:nvPr/>
        </p:nvSpPr>
        <p:spPr>
          <a:xfrm>
            <a:off x="142392" y="98552"/>
            <a:ext cx="10963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Figure 7H</a:t>
            </a:r>
            <a:endParaRPr lang="en-US" sz="1600" b="1" i="1" baseline="30000" dirty="0"/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12670738-96E5-914C-EFB2-5D9954495694}"/>
              </a:ext>
            </a:extLst>
          </p:cNvPr>
          <p:cNvGrpSpPr/>
          <p:nvPr/>
        </p:nvGrpSpPr>
        <p:grpSpPr>
          <a:xfrm>
            <a:off x="2124379" y="231701"/>
            <a:ext cx="7943242" cy="5981121"/>
            <a:chOff x="1449143" y="231701"/>
            <a:chExt cx="7943242" cy="5981121"/>
          </a:xfrm>
        </p:grpSpPr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7E590D9B-D5AC-F2E6-0BC8-E472E5CAF306}"/>
                </a:ext>
              </a:extLst>
            </p:cNvPr>
            <p:cNvGrpSpPr/>
            <p:nvPr/>
          </p:nvGrpSpPr>
          <p:grpSpPr>
            <a:xfrm>
              <a:off x="1477135" y="231701"/>
              <a:ext cx="7887259" cy="2542497"/>
              <a:chOff x="1444610" y="231701"/>
              <a:chExt cx="7887259" cy="2542497"/>
            </a:xfrm>
          </p:grpSpPr>
          <p:pic>
            <p:nvPicPr>
              <p:cNvPr id="4" name="Picture 3" descr="A close-up of a test&#10;&#10;Description automatically generated">
                <a:extLst>
                  <a:ext uri="{FF2B5EF4-FFF2-40B4-BE49-F238E27FC236}">
                    <a16:creationId xmlns:a16="http://schemas.microsoft.com/office/drawing/2014/main" id="{FBAB2912-00CE-1B7F-0960-48DE6DC1CD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80" t="-1120" r="5963" b="-3771"/>
              <a:stretch>
                <a:fillRect/>
              </a:stretch>
            </p:blipFill>
            <p:spPr>
              <a:xfrm>
                <a:off x="2605377" y="1254556"/>
                <a:ext cx="5021108" cy="1519642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A5DAEF4-A651-4DCD-35F4-97805E619026}"/>
                  </a:ext>
                </a:extLst>
              </p:cNvPr>
              <p:cNvSpPr txBox="1"/>
              <p:nvPr/>
            </p:nvSpPr>
            <p:spPr>
              <a:xfrm>
                <a:off x="7966468" y="1466736"/>
                <a:ext cx="1365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STAT3</a:t>
                </a:r>
                <a:r>
                  <a:rPr lang="en-US" sz="14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Tyr705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77E58CAA-AF46-6EA1-6BAD-33A79A8DDF15}"/>
                  </a:ext>
                </a:extLst>
              </p:cNvPr>
              <p:cNvSpPr/>
              <p:nvPr/>
            </p:nvSpPr>
            <p:spPr>
              <a:xfrm>
                <a:off x="2860131" y="1420240"/>
                <a:ext cx="1791180" cy="32349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3CB0E1C6-80FE-AC2B-2299-68D75440F026}"/>
                  </a:ext>
                </a:extLst>
              </p:cNvPr>
              <p:cNvGrpSpPr/>
              <p:nvPr/>
            </p:nvGrpSpPr>
            <p:grpSpPr>
              <a:xfrm>
                <a:off x="2796595" y="231701"/>
                <a:ext cx="1868317" cy="1108954"/>
                <a:chOff x="2796595" y="354916"/>
                <a:chExt cx="1868317" cy="1108954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0E62A87-5B90-E115-81E5-E523857904D8}"/>
                    </a:ext>
                  </a:extLst>
                </p:cNvPr>
                <p:cNvSpPr txBox="1"/>
                <p:nvPr/>
              </p:nvSpPr>
              <p:spPr>
                <a:xfrm rot="16200000">
                  <a:off x="235753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86216205-41A7-35B1-2C42-1A47A3FAC53E}"/>
                    </a:ext>
                  </a:extLst>
                </p:cNvPr>
                <p:cNvSpPr txBox="1"/>
                <p:nvPr/>
              </p:nvSpPr>
              <p:spPr>
                <a:xfrm rot="16200000">
                  <a:off x="2539477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2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BBC172C9-1B49-36D8-DFB7-1CCDA0CA26BC}"/>
                    </a:ext>
                  </a:extLst>
                </p:cNvPr>
                <p:cNvSpPr txBox="1"/>
                <p:nvPr/>
              </p:nvSpPr>
              <p:spPr>
                <a:xfrm rot="16200000">
                  <a:off x="272142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3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D6A15358-A13C-32DC-C4EE-9BA9B7425826}"/>
                    </a:ext>
                  </a:extLst>
                </p:cNvPr>
                <p:cNvSpPr txBox="1"/>
                <p:nvPr/>
              </p:nvSpPr>
              <p:spPr>
                <a:xfrm rot="16200000">
                  <a:off x="2903363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4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81C21108-38B1-9330-0426-B552A3E46F4B}"/>
                    </a:ext>
                  </a:extLst>
                </p:cNvPr>
                <p:cNvSpPr txBox="1"/>
                <p:nvPr/>
              </p:nvSpPr>
              <p:spPr>
                <a:xfrm rot="16200000">
                  <a:off x="308530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5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F09E0A53-FEA9-F72A-A697-65A181DA258A}"/>
                    </a:ext>
                  </a:extLst>
                </p:cNvPr>
                <p:cNvSpPr txBox="1"/>
                <p:nvPr/>
              </p:nvSpPr>
              <p:spPr>
                <a:xfrm rot="16200000">
                  <a:off x="326724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6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9F93166-1B32-95B2-A6B2-FB1476F8153B}"/>
                    </a:ext>
                  </a:extLst>
                </p:cNvPr>
                <p:cNvSpPr txBox="1"/>
                <p:nvPr/>
              </p:nvSpPr>
              <p:spPr>
                <a:xfrm rot="16200000">
                  <a:off x="3449192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7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42EC1570-3A8E-390D-2E33-DF95D85705F4}"/>
                    </a:ext>
                  </a:extLst>
                </p:cNvPr>
                <p:cNvSpPr txBox="1"/>
                <p:nvPr/>
              </p:nvSpPr>
              <p:spPr>
                <a:xfrm rot="16200000">
                  <a:off x="3631135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8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A9947FA0-6BB6-631E-FF0B-1D08916EA662}"/>
                    </a:ext>
                  </a:extLst>
                </p:cNvPr>
                <p:cNvSpPr txBox="1"/>
                <p:nvPr/>
              </p:nvSpPr>
              <p:spPr>
                <a:xfrm rot="16200000">
                  <a:off x="381307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9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EFD8E644-C96E-0AE0-0514-07A58C81F6E2}"/>
                    </a:ext>
                  </a:extLst>
                </p:cNvPr>
                <p:cNvSpPr txBox="1"/>
                <p:nvPr/>
              </p:nvSpPr>
              <p:spPr>
                <a:xfrm rot="16200000">
                  <a:off x="399501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0</a:t>
                  </a:r>
                </a:p>
              </p:txBody>
            </p: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CE6F8625-E05F-37AD-5067-61968D0237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40676" y="836577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id="{6A92FEBD-E8DA-D81A-187E-6B9A8390D5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35745" y="836577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12FA778-BB31-DF82-6331-B24893E2DFDF}"/>
                    </a:ext>
                  </a:extLst>
                </p:cNvPr>
                <p:cNvSpPr txBox="1"/>
                <p:nvPr/>
              </p:nvSpPr>
              <p:spPr>
                <a:xfrm>
                  <a:off x="2888800" y="633096"/>
                  <a:ext cx="7786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33BE8610-BAFC-9FEF-CBC3-C2DD98E16252}"/>
                    </a:ext>
                  </a:extLst>
                </p:cNvPr>
                <p:cNvSpPr txBox="1"/>
                <p:nvPr/>
              </p:nvSpPr>
              <p:spPr>
                <a:xfrm>
                  <a:off x="3679336" y="636500"/>
                  <a:ext cx="97027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NCRISTINE</a:t>
                  </a:r>
                </a:p>
              </p:txBody>
            </p: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8D1E6C3-1A7D-1005-2B34-4ADC211F017F}"/>
                  </a:ext>
                </a:extLst>
              </p:cNvPr>
              <p:cNvSpPr txBox="1"/>
              <p:nvPr/>
            </p:nvSpPr>
            <p:spPr>
              <a:xfrm>
                <a:off x="1444610" y="132016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C24A45A6-6892-376A-A057-6F48474F24A9}"/>
                  </a:ext>
                </a:extLst>
              </p:cNvPr>
              <p:cNvSpPr txBox="1"/>
              <p:nvPr/>
            </p:nvSpPr>
            <p:spPr>
              <a:xfrm>
                <a:off x="1444610" y="1465699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B1ECC18D-4F6E-459F-E23A-4838E6FD0C95}"/>
                  </a:ext>
                </a:extLst>
              </p:cNvPr>
              <p:cNvSpPr txBox="1"/>
              <p:nvPr/>
            </p:nvSpPr>
            <p:spPr>
              <a:xfrm>
                <a:off x="1444610" y="1604034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6D06C570-21BC-9DA4-0245-13453526CA4C}"/>
                  </a:ext>
                </a:extLst>
              </p:cNvPr>
              <p:cNvSpPr txBox="1"/>
              <p:nvPr/>
            </p:nvSpPr>
            <p:spPr>
              <a:xfrm>
                <a:off x="1444610" y="1750337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8E137A36-A91F-70E9-4C58-D236DA8EF38E}"/>
                  </a:ext>
                </a:extLst>
              </p:cNvPr>
              <p:cNvSpPr txBox="1"/>
              <p:nvPr/>
            </p:nvSpPr>
            <p:spPr>
              <a:xfrm>
                <a:off x="1444610" y="191192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11123976-C113-1596-51D1-9249084A6831}"/>
                  </a:ext>
                </a:extLst>
              </p:cNvPr>
              <p:cNvSpPr txBox="1"/>
              <p:nvPr/>
            </p:nvSpPr>
            <p:spPr>
              <a:xfrm>
                <a:off x="1444610" y="207350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DA35DB5E-C1E2-0DB1-ED23-091E8DF55295}"/>
                  </a:ext>
                </a:extLst>
              </p:cNvPr>
              <p:cNvSpPr txBox="1"/>
              <p:nvPr/>
            </p:nvSpPr>
            <p:spPr>
              <a:xfrm>
                <a:off x="1444610" y="112712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C47295B-2A25-B9D2-5417-B94763658C85}"/>
                  </a:ext>
                </a:extLst>
              </p:cNvPr>
              <p:cNvSpPr txBox="1"/>
              <p:nvPr/>
            </p:nvSpPr>
            <p:spPr>
              <a:xfrm>
                <a:off x="1444610" y="2304116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883DC877-2A89-80C0-83AB-24CE04377E99}"/>
                </a:ext>
              </a:extLst>
            </p:cNvPr>
            <p:cNvGrpSpPr/>
            <p:nvPr/>
          </p:nvGrpSpPr>
          <p:grpSpPr>
            <a:xfrm>
              <a:off x="1449143" y="3241874"/>
              <a:ext cx="7943242" cy="2970948"/>
              <a:chOff x="1453677" y="2972240"/>
              <a:chExt cx="7943242" cy="2970948"/>
            </a:xfrm>
          </p:grpSpPr>
          <p:pic>
            <p:nvPicPr>
              <p:cNvPr id="5" name="Picture 4" descr="A close-up of a test&#10;&#10;Description automatically generated">
                <a:extLst>
                  <a:ext uri="{FF2B5EF4-FFF2-40B4-BE49-F238E27FC236}">
                    <a16:creationId xmlns:a16="http://schemas.microsoft.com/office/drawing/2014/main" id="{F1AD7AEA-9180-16F7-8865-6E3E85691A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65" t="-524" r="3958" b="885"/>
              <a:stretch>
                <a:fillRect/>
              </a:stretch>
            </p:blipFill>
            <p:spPr>
              <a:xfrm>
                <a:off x="2605377" y="4009859"/>
                <a:ext cx="5021108" cy="1933329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B6A5D9C-AE96-7164-516A-7E9452FCE52E}"/>
                  </a:ext>
                </a:extLst>
              </p:cNvPr>
              <p:cNvSpPr txBox="1"/>
              <p:nvPr/>
            </p:nvSpPr>
            <p:spPr>
              <a:xfrm>
                <a:off x="7913169" y="4386551"/>
                <a:ext cx="14837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STAT3</a:t>
                </a:r>
                <a:endPara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277F1DE4-B291-539D-ED79-433E70109FEB}"/>
                  </a:ext>
                </a:extLst>
              </p:cNvPr>
              <p:cNvSpPr/>
              <p:nvPr/>
            </p:nvSpPr>
            <p:spPr>
              <a:xfrm>
                <a:off x="2875336" y="4326288"/>
                <a:ext cx="1791180" cy="32349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1D17102A-5995-33AB-9DA2-E5E3A624E2F5}"/>
                  </a:ext>
                </a:extLst>
              </p:cNvPr>
              <p:cNvGrpSpPr/>
              <p:nvPr/>
            </p:nvGrpSpPr>
            <p:grpSpPr>
              <a:xfrm>
                <a:off x="2833976" y="2972240"/>
                <a:ext cx="1868317" cy="1108954"/>
                <a:chOff x="2796595" y="354916"/>
                <a:chExt cx="1868317" cy="1108954"/>
              </a:xfrm>
            </p:grpSpPr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7E0486D4-E177-7CA3-2D98-C272E718A773}"/>
                    </a:ext>
                  </a:extLst>
                </p:cNvPr>
                <p:cNvSpPr txBox="1"/>
                <p:nvPr/>
              </p:nvSpPr>
              <p:spPr>
                <a:xfrm rot="16200000">
                  <a:off x="235753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1102B79-90DE-CA8B-3B59-A35D1FDEF5BA}"/>
                    </a:ext>
                  </a:extLst>
                </p:cNvPr>
                <p:cNvSpPr txBox="1"/>
                <p:nvPr/>
              </p:nvSpPr>
              <p:spPr>
                <a:xfrm rot="16200000">
                  <a:off x="2539477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2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6B4651A-DB0A-C8B0-C5B0-111737E000A4}"/>
                    </a:ext>
                  </a:extLst>
                </p:cNvPr>
                <p:cNvSpPr txBox="1"/>
                <p:nvPr/>
              </p:nvSpPr>
              <p:spPr>
                <a:xfrm rot="16200000">
                  <a:off x="272142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3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6A2D0D52-9174-E903-8CAF-AFD52B198004}"/>
                    </a:ext>
                  </a:extLst>
                </p:cNvPr>
                <p:cNvSpPr txBox="1"/>
                <p:nvPr/>
              </p:nvSpPr>
              <p:spPr>
                <a:xfrm rot="16200000">
                  <a:off x="2903363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4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B0A1F06D-F77B-72E4-FA4E-596AC655CAD6}"/>
                    </a:ext>
                  </a:extLst>
                </p:cNvPr>
                <p:cNvSpPr txBox="1"/>
                <p:nvPr/>
              </p:nvSpPr>
              <p:spPr>
                <a:xfrm rot="16200000">
                  <a:off x="308530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5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CE6777BC-4280-4BF3-3090-29DEA720F186}"/>
                    </a:ext>
                  </a:extLst>
                </p:cNvPr>
                <p:cNvSpPr txBox="1"/>
                <p:nvPr/>
              </p:nvSpPr>
              <p:spPr>
                <a:xfrm rot="16200000">
                  <a:off x="326724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6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72CA0F22-496D-1F8C-B104-042C2987E32B}"/>
                    </a:ext>
                  </a:extLst>
                </p:cNvPr>
                <p:cNvSpPr txBox="1"/>
                <p:nvPr/>
              </p:nvSpPr>
              <p:spPr>
                <a:xfrm rot="16200000">
                  <a:off x="3449192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7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1EEDFAAD-87C5-7D1F-6828-71EA04B2624D}"/>
                    </a:ext>
                  </a:extLst>
                </p:cNvPr>
                <p:cNvSpPr txBox="1"/>
                <p:nvPr/>
              </p:nvSpPr>
              <p:spPr>
                <a:xfrm rot="16200000">
                  <a:off x="3631135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8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3DC68430-DD3D-CB92-FD2A-ECCA880318D9}"/>
                    </a:ext>
                  </a:extLst>
                </p:cNvPr>
                <p:cNvSpPr txBox="1"/>
                <p:nvPr/>
              </p:nvSpPr>
              <p:spPr>
                <a:xfrm rot="16200000">
                  <a:off x="381307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9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5262D5D2-7C19-9826-CF69-9A5872FCFA59}"/>
                    </a:ext>
                  </a:extLst>
                </p:cNvPr>
                <p:cNvSpPr txBox="1"/>
                <p:nvPr/>
              </p:nvSpPr>
              <p:spPr>
                <a:xfrm rot="16200000">
                  <a:off x="399501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0</a:t>
                  </a:r>
                </a:p>
              </p:txBody>
            </p: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id="{E8515761-A8BD-9574-FC36-67FF3E83C6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40676" y="836577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0B6E249F-C2DE-FB25-38A0-D489844FFA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35745" y="836577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EE6A4503-3BDD-FD64-B66A-FE03F6BFBFE9}"/>
                    </a:ext>
                  </a:extLst>
                </p:cNvPr>
                <p:cNvSpPr txBox="1"/>
                <p:nvPr/>
              </p:nvSpPr>
              <p:spPr>
                <a:xfrm>
                  <a:off x="2888800" y="633096"/>
                  <a:ext cx="7786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645E540B-29A7-98B9-F91C-C95ACD954CB6}"/>
                    </a:ext>
                  </a:extLst>
                </p:cNvPr>
                <p:cNvSpPr txBox="1"/>
                <p:nvPr/>
              </p:nvSpPr>
              <p:spPr>
                <a:xfrm>
                  <a:off x="3679336" y="636500"/>
                  <a:ext cx="97027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NCRISTINE</a:t>
                  </a:r>
                </a:p>
              </p:txBody>
            </p:sp>
          </p:grp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6B18E3D1-C67F-6F82-F5D7-B506C7462971}"/>
                  </a:ext>
                </a:extLst>
              </p:cNvPr>
              <p:cNvSpPr txBox="1"/>
              <p:nvPr/>
            </p:nvSpPr>
            <p:spPr>
              <a:xfrm>
                <a:off x="1454542" y="4185481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4BA4646-8D30-1BB4-5CFF-C136CA786D05}"/>
                  </a:ext>
                </a:extLst>
              </p:cNvPr>
              <p:cNvSpPr txBox="1"/>
              <p:nvPr/>
            </p:nvSpPr>
            <p:spPr>
              <a:xfrm>
                <a:off x="1454542" y="436150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534EB215-6A23-5AE7-5F82-A8C44E328889}"/>
                  </a:ext>
                </a:extLst>
              </p:cNvPr>
              <p:cNvSpPr txBox="1"/>
              <p:nvPr/>
            </p:nvSpPr>
            <p:spPr>
              <a:xfrm>
                <a:off x="1454542" y="4565875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35EBD1A6-0930-39A5-58B6-14EF865891F8}"/>
                  </a:ext>
                </a:extLst>
              </p:cNvPr>
              <p:cNvSpPr txBox="1"/>
              <p:nvPr/>
            </p:nvSpPr>
            <p:spPr>
              <a:xfrm>
                <a:off x="1454542" y="4768058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E9DAC92A-8A34-2BCB-ECC5-CFCFB8F14366}"/>
                  </a:ext>
                </a:extLst>
              </p:cNvPr>
              <p:cNvSpPr txBox="1"/>
              <p:nvPr/>
            </p:nvSpPr>
            <p:spPr>
              <a:xfrm>
                <a:off x="1454542" y="4970281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55898023-A3E6-36A9-7657-AEF37539E252}"/>
                  </a:ext>
                </a:extLst>
              </p:cNvPr>
              <p:cNvSpPr txBox="1"/>
              <p:nvPr/>
            </p:nvSpPr>
            <p:spPr>
              <a:xfrm>
                <a:off x="1454542" y="5197903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5E900801-1592-3BF4-2363-7DB2948C3AEA}"/>
                  </a:ext>
                </a:extLst>
              </p:cNvPr>
              <p:cNvSpPr txBox="1"/>
              <p:nvPr/>
            </p:nvSpPr>
            <p:spPr>
              <a:xfrm>
                <a:off x="1454542" y="5514877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F317E3B-9269-980D-6FE2-4EFB8FD06E46}"/>
                  </a:ext>
                </a:extLst>
              </p:cNvPr>
              <p:cNvSpPr txBox="1"/>
              <p:nvPr/>
            </p:nvSpPr>
            <p:spPr>
              <a:xfrm>
                <a:off x="1453677" y="392172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81351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EB44D22F-85D0-3C57-9162-B08A345C7D27}"/>
              </a:ext>
            </a:extLst>
          </p:cNvPr>
          <p:cNvSpPr txBox="1"/>
          <p:nvPr/>
        </p:nvSpPr>
        <p:spPr>
          <a:xfrm>
            <a:off x="142392" y="98552"/>
            <a:ext cx="10963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Figure 7H</a:t>
            </a:r>
            <a:endParaRPr lang="en-US" sz="1600" b="1" i="1" baseline="30000" dirty="0"/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F467793D-AFC5-6655-6E39-20A259DB1B6F}"/>
              </a:ext>
            </a:extLst>
          </p:cNvPr>
          <p:cNvGrpSpPr/>
          <p:nvPr/>
        </p:nvGrpSpPr>
        <p:grpSpPr>
          <a:xfrm>
            <a:off x="2251255" y="489734"/>
            <a:ext cx="7689491" cy="5188378"/>
            <a:chOff x="1380045" y="354916"/>
            <a:chExt cx="7689491" cy="5188378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6240E221-5927-7E2F-D583-5CDA85269A13}"/>
                </a:ext>
              </a:extLst>
            </p:cNvPr>
            <p:cNvGrpSpPr/>
            <p:nvPr/>
          </p:nvGrpSpPr>
          <p:grpSpPr>
            <a:xfrm>
              <a:off x="1380045" y="354916"/>
              <a:ext cx="7622498" cy="2419088"/>
              <a:chOff x="1380045" y="354916"/>
              <a:chExt cx="7622498" cy="2419088"/>
            </a:xfrm>
          </p:grpSpPr>
          <p:pic>
            <p:nvPicPr>
              <p:cNvPr id="11" name="Picture 10" descr="A close-up of a line&#10;&#10;Description automatically generated">
                <a:extLst>
                  <a:ext uri="{FF2B5EF4-FFF2-40B4-BE49-F238E27FC236}">
                    <a16:creationId xmlns:a16="http://schemas.microsoft.com/office/drawing/2014/main" id="{2B8392D5-352B-A279-542B-91B284E293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458" t="21841" r="8096" b="21687"/>
              <a:stretch>
                <a:fillRect/>
              </a:stretch>
            </p:blipFill>
            <p:spPr>
              <a:xfrm>
                <a:off x="2522498" y="1416433"/>
                <a:ext cx="5333988" cy="1357571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65C49E7A-33D1-B6BE-B526-F81B66EE86DD}"/>
                  </a:ext>
                </a:extLst>
              </p:cNvPr>
              <p:cNvSpPr/>
              <p:nvPr/>
            </p:nvSpPr>
            <p:spPr>
              <a:xfrm>
                <a:off x="2830157" y="1704092"/>
                <a:ext cx="1928827" cy="410499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B233A91-1098-7E7E-BB33-9E5130EDEF8B}"/>
                  </a:ext>
                </a:extLst>
              </p:cNvPr>
              <p:cNvSpPr txBox="1"/>
              <p:nvPr/>
            </p:nvSpPr>
            <p:spPr>
              <a:xfrm>
                <a:off x="7906154" y="1848997"/>
                <a:ext cx="10963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AKT</a:t>
                </a:r>
                <a:r>
                  <a:rPr lang="en-US" sz="1400" b="1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er473</a:t>
                </a:r>
              </a:p>
            </p:txBody>
          </p: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67776C66-231C-5983-CB59-C13635FFC752}"/>
                  </a:ext>
                </a:extLst>
              </p:cNvPr>
              <p:cNvGrpSpPr/>
              <p:nvPr/>
            </p:nvGrpSpPr>
            <p:grpSpPr>
              <a:xfrm>
                <a:off x="2796595" y="354916"/>
                <a:ext cx="1972077" cy="1108954"/>
                <a:chOff x="2796595" y="354916"/>
                <a:chExt cx="1972077" cy="1108954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8C5E317A-7EC3-4C39-9253-3D0381E69812}"/>
                    </a:ext>
                  </a:extLst>
                </p:cNvPr>
                <p:cNvSpPr txBox="1"/>
                <p:nvPr/>
              </p:nvSpPr>
              <p:spPr>
                <a:xfrm rot="16200000">
                  <a:off x="235753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C3C08E02-5D70-DE02-1A17-C7F93E30DF5C}"/>
                    </a:ext>
                  </a:extLst>
                </p:cNvPr>
                <p:cNvSpPr txBox="1"/>
                <p:nvPr/>
              </p:nvSpPr>
              <p:spPr>
                <a:xfrm rot="16200000">
                  <a:off x="255100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2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6F347BBE-164E-2907-0A04-EF37B9A8197B}"/>
                    </a:ext>
                  </a:extLst>
                </p:cNvPr>
                <p:cNvSpPr txBox="1"/>
                <p:nvPr/>
              </p:nvSpPr>
              <p:spPr>
                <a:xfrm rot="16200000">
                  <a:off x="274447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3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CB8B517E-FFF4-FE15-7118-E642ADB44E91}"/>
                    </a:ext>
                  </a:extLst>
                </p:cNvPr>
                <p:cNvSpPr txBox="1"/>
                <p:nvPr/>
              </p:nvSpPr>
              <p:spPr>
                <a:xfrm rot="16200000">
                  <a:off x="293795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4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9E054685-1914-3628-DD11-3F2CC2AA9784}"/>
                    </a:ext>
                  </a:extLst>
                </p:cNvPr>
                <p:cNvSpPr txBox="1"/>
                <p:nvPr/>
              </p:nvSpPr>
              <p:spPr>
                <a:xfrm rot="16200000">
                  <a:off x="3131422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5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0DB22760-DD03-9143-9917-CCAE91D874D3}"/>
                    </a:ext>
                  </a:extLst>
                </p:cNvPr>
                <p:cNvSpPr txBox="1"/>
                <p:nvPr/>
              </p:nvSpPr>
              <p:spPr>
                <a:xfrm rot="16200000">
                  <a:off x="332489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6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9C9F2753-FD05-EC7D-48B4-4D488AB38334}"/>
                    </a:ext>
                  </a:extLst>
                </p:cNvPr>
                <p:cNvSpPr txBox="1"/>
                <p:nvPr/>
              </p:nvSpPr>
              <p:spPr>
                <a:xfrm rot="16200000">
                  <a:off x="351836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7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821D85DE-274D-FCC0-22C7-5E4258BBEE7C}"/>
                    </a:ext>
                  </a:extLst>
                </p:cNvPr>
                <p:cNvSpPr txBox="1"/>
                <p:nvPr/>
              </p:nvSpPr>
              <p:spPr>
                <a:xfrm rot="16200000">
                  <a:off x="371183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8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9E4A1FE3-7D4E-FDAF-EABA-8CA27867162B}"/>
                    </a:ext>
                  </a:extLst>
                </p:cNvPr>
                <p:cNvSpPr txBox="1"/>
                <p:nvPr/>
              </p:nvSpPr>
              <p:spPr>
                <a:xfrm rot="16200000">
                  <a:off x="390531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9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1600440-F114-BA0A-048B-715D8030834A}"/>
                    </a:ext>
                  </a:extLst>
                </p:cNvPr>
                <p:cNvSpPr txBox="1"/>
                <p:nvPr/>
              </p:nvSpPr>
              <p:spPr>
                <a:xfrm rot="16200000">
                  <a:off x="409877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0</a:t>
                  </a:r>
                </a:p>
              </p:txBody>
            </p: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85787BD7-EF07-6754-FC9F-4CE57C7EE7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64464" y="853218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70FB7796-00F9-F1B0-19A7-F33D22982B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24383" y="853218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2CA22B2-9E8B-02FF-AA5F-70B40895E510}"/>
                    </a:ext>
                  </a:extLst>
                </p:cNvPr>
                <p:cNvSpPr txBox="1"/>
                <p:nvPr/>
              </p:nvSpPr>
              <p:spPr>
                <a:xfrm>
                  <a:off x="2912588" y="649737"/>
                  <a:ext cx="7786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5A3D89C9-753B-68AF-4603-DD8DD2003BC4}"/>
                    </a:ext>
                  </a:extLst>
                </p:cNvPr>
                <p:cNvSpPr txBox="1"/>
                <p:nvPr/>
              </p:nvSpPr>
              <p:spPr>
                <a:xfrm>
                  <a:off x="3767974" y="653141"/>
                  <a:ext cx="97027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NCRISTINE</a:t>
                  </a:r>
                </a:p>
              </p:txBody>
            </p:sp>
          </p:grp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B901349-83B4-6553-227D-59547FD756A0}"/>
                  </a:ext>
                </a:extLst>
              </p:cNvPr>
              <p:cNvSpPr txBox="1"/>
              <p:nvPr/>
            </p:nvSpPr>
            <p:spPr>
              <a:xfrm>
                <a:off x="1380045" y="1364726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053BC0B5-F003-DE44-244C-E294EBCB8762}"/>
                  </a:ext>
                </a:extLst>
              </p:cNvPr>
              <p:cNvSpPr txBox="1"/>
              <p:nvPr/>
            </p:nvSpPr>
            <p:spPr>
              <a:xfrm>
                <a:off x="1380045" y="1655461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FB4F6C3F-0357-39A6-49E2-718BAE55E654}"/>
                  </a:ext>
                </a:extLst>
              </p:cNvPr>
              <p:cNvSpPr txBox="1"/>
              <p:nvPr/>
            </p:nvSpPr>
            <p:spPr>
              <a:xfrm>
                <a:off x="1380045" y="1949084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CD2968E-DC33-9E18-C5D8-2500D7D06068}"/>
                  </a:ext>
                </a:extLst>
              </p:cNvPr>
              <p:cNvSpPr txBox="1"/>
              <p:nvPr/>
            </p:nvSpPr>
            <p:spPr>
              <a:xfrm>
                <a:off x="1380045" y="2273227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29733D15-510E-23D3-EC73-4BC70288E59F}"/>
                </a:ext>
              </a:extLst>
            </p:cNvPr>
            <p:cNvGrpSpPr/>
            <p:nvPr/>
          </p:nvGrpSpPr>
          <p:grpSpPr>
            <a:xfrm>
              <a:off x="1390338" y="3150442"/>
              <a:ext cx="7679198" cy="2392852"/>
              <a:chOff x="1390338" y="2845639"/>
              <a:chExt cx="7679198" cy="2392852"/>
            </a:xfrm>
          </p:grpSpPr>
          <p:pic>
            <p:nvPicPr>
              <p:cNvPr id="13" name="Picture 12" descr="A close-up of a black and white photo&#10;&#10;Description automatically generated">
                <a:extLst>
                  <a:ext uri="{FF2B5EF4-FFF2-40B4-BE49-F238E27FC236}">
                    <a16:creationId xmlns:a16="http://schemas.microsoft.com/office/drawing/2014/main" id="{142EC758-12BC-2E5D-E2C0-BDEE0F8444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7" t="18634" r="1595" b="27034"/>
              <a:stretch>
                <a:fillRect/>
              </a:stretch>
            </p:blipFill>
            <p:spPr>
              <a:xfrm>
                <a:off x="2561614" y="3880920"/>
                <a:ext cx="5333988" cy="1357571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FF89F6CC-5EF0-4422-C006-225AE2657AC3}"/>
                  </a:ext>
                </a:extLst>
              </p:cNvPr>
              <p:cNvSpPr/>
              <p:nvPr/>
            </p:nvSpPr>
            <p:spPr>
              <a:xfrm>
                <a:off x="2881218" y="4210154"/>
                <a:ext cx="1928827" cy="410499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0654FCF-545C-4F10-5450-298150A188F8}"/>
                  </a:ext>
                </a:extLst>
              </p:cNvPr>
              <p:cNvSpPr txBox="1"/>
              <p:nvPr/>
            </p:nvSpPr>
            <p:spPr>
              <a:xfrm>
                <a:off x="7973147" y="4469958"/>
                <a:ext cx="10963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AKT</a:t>
                </a:r>
                <a:endParaRPr lang="en-US" sz="1400" b="1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697FAD5A-267E-F7B7-56B9-B8526F44472A}"/>
                  </a:ext>
                </a:extLst>
              </p:cNvPr>
              <p:cNvGrpSpPr/>
              <p:nvPr/>
            </p:nvGrpSpPr>
            <p:grpSpPr>
              <a:xfrm>
                <a:off x="2837968" y="2845639"/>
                <a:ext cx="1972077" cy="1108954"/>
                <a:chOff x="2796595" y="354916"/>
                <a:chExt cx="1972077" cy="1108954"/>
              </a:xfrm>
            </p:grpSpPr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28833F6C-2643-ED70-D15E-209F21A0160D}"/>
                    </a:ext>
                  </a:extLst>
                </p:cNvPr>
                <p:cNvSpPr txBox="1"/>
                <p:nvPr/>
              </p:nvSpPr>
              <p:spPr>
                <a:xfrm rot="16200000">
                  <a:off x="235753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13360A53-E354-47A4-4384-AAA9D4D5E294}"/>
                    </a:ext>
                  </a:extLst>
                </p:cNvPr>
                <p:cNvSpPr txBox="1"/>
                <p:nvPr/>
              </p:nvSpPr>
              <p:spPr>
                <a:xfrm rot="16200000">
                  <a:off x="255100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2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3DD3975-6958-80C8-667F-425D171BFC51}"/>
                    </a:ext>
                  </a:extLst>
                </p:cNvPr>
                <p:cNvSpPr txBox="1"/>
                <p:nvPr/>
              </p:nvSpPr>
              <p:spPr>
                <a:xfrm rot="16200000">
                  <a:off x="274447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3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54FF867D-A6E6-3B23-576B-E15B2604BD46}"/>
                    </a:ext>
                  </a:extLst>
                </p:cNvPr>
                <p:cNvSpPr txBox="1"/>
                <p:nvPr/>
              </p:nvSpPr>
              <p:spPr>
                <a:xfrm rot="16200000">
                  <a:off x="293795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4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83ED9C10-DF9C-C215-3B19-ABCC3D6039D7}"/>
                    </a:ext>
                  </a:extLst>
                </p:cNvPr>
                <p:cNvSpPr txBox="1"/>
                <p:nvPr/>
              </p:nvSpPr>
              <p:spPr>
                <a:xfrm rot="16200000">
                  <a:off x="3131422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5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3315730D-537F-CCE9-1FB0-496BB2059A48}"/>
                    </a:ext>
                  </a:extLst>
                </p:cNvPr>
                <p:cNvSpPr txBox="1"/>
                <p:nvPr/>
              </p:nvSpPr>
              <p:spPr>
                <a:xfrm rot="16200000">
                  <a:off x="3324894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6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0DA0EE26-5D1C-9E7D-1A0D-89048A0AC88E}"/>
                    </a:ext>
                  </a:extLst>
                </p:cNvPr>
                <p:cNvSpPr txBox="1"/>
                <p:nvPr/>
              </p:nvSpPr>
              <p:spPr>
                <a:xfrm rot="16200000">
                  <a:off x="3518366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7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6D508167-4CD1-6D9C-E262-0E021A26C67B}"/>
                    </a:ext>
                  </a:extLst>
                </p:cNvPr>
                <p:cNvSpPr txBox="1"/>
                <p:nvPr/>
              </p:nvSpPr>
              <p:spPr>
                <a:xfrm rot="16200000">
                  <a:off x="3711838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8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D9CA2868-663F-97C6-37D0-E3F594159FCD}"/>
                    </a:ext>
                  </a:extLst>
                </p:cNvPr>
                <p:cNvSpPr txBox="1"/>
                <p:nvPr/>
              </p:nvSpPr>
              <p:spPr>
                <a:xfrm rot="16200000">
                  <a:off x="3905310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9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52B0849D-8039-0258-A2F9-ED0B80725CD6}"/>
                    </a:ext>
                  </a:extLst>
                </p:cNvPr>
                <p:cNvSpPr txBox="1"/>
                <p:nvPr/>
              </p:nvSpPr>
              <p:spPr>
                <a:xfrm rot="16200000">
                  <a:off x="4098779" y="793977"/>
                  <a:ext cx="11089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17.10</a:t>
                  </a:r>
                </a:p>
              </p:txBody>
            </p:sp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id="{2F50D3E1-B12A-B44C-FA0D-4A1A757356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64464" y="853218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D9975E9C-FD1D-3CF5-445A-86BD945E5B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24383" y="853218"/>
                  <a:ext cx="846179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760E3DDE-D174-D3D0-2DBD-CF0AD1CF67D1}"/>
                    </a:ext>
                  </a:extLst>
                </p:cNvPr>
                <p:cNvSpPr txBox="1"/>
                <p:nvPr/>
              </p:nvSpPr>
              <p:spPr>
                <a:xfrm>
                  <a:off x="2912588" y="649737"/>
                  <a:ext cx="7786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F6F6CF06-CD8D-D0CA-0DB7-A50266F93C67}"/>
                    </a:ext>
                  </a:extLst>
                </p:cNvPr>
                <p:cNvSpPr txBox="1"/>
                <p:nvPr/>
              </p:nvSpPr>
              <p:spPr>
                <a:xfrm>
                  <a:off x="3767974" y="653141"/>
                  <a:ext cx="97027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NCRISTINE</a:t>
                  </a:r>
                </a:p>
              </p:txBody>
            </p:sp>
          </p:grp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F9B8BA50-2BA4-4555-E2B5-999CEC7CA315}"/>
                  </a:ext>
                </a:extLst>
              </p:cNvPr>
              <p:cNvSpPr txBox="1"/>
              <p:nvPr/>
            </p:nvSpPr>
            <p:spPr>
              <a:xfrm>
                <a:off x="1390338" y="3835521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B3B1192-AE0D-4A49-5C3A-55EE4D5F820F}"/>
                  </a:ext>
                </a:extLst>
              </p:cNvPr>
              <p:cNvSpPr txBox="1"/>
              <p:nvPr/>
            </p:nvSpPr>
            <p:spPr>
              <a:xfrm>
                <a:off x="1390338" y="4126256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0F10022F-8FEA-9ECD-6FB0-98B4005A9A61}"/>
                  </a:ext>
                </a:extLst>
              </p:cNvPr>
              <p:cNvSpPr txBox="1"/>
              <p:nvPr/>
            </p:nvSpPr>
            <p:spPr>
              <a:xfrm>
                <a:off x="1390338" y="4419879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8D7822ED-9DC8-2F59-1671-17369A04CDAB}"/>
                  </a:ext>
                </a:extLst>
              </p:cNvPr>
              <p:cNvSpPr txBox="1"/>
              <p:nvPr/>
            </p:nvSpPr>
            <p:spPr>
              <a:xfrm>
                <a:off x="1390338" y="474402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4269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4AC9C18D-0F9A-8E42-5219-20359771142C}"/>
              </a:ext>
            </a:extLst>
          </p:cNvPr>
          <p:cNvSpPr txBox="1"/>
          <p:nvPr/>
        </p:nvSpPr>
        <p:spPr>
          <a:xfrm>
            <a:off x="142392" y="98552"/>
            <a:ext cx="10963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/>
              <a:t>Figure 7H</a:t>
            </a:r>
            <a:endParaRPr lang="en-US" sz="1600" b="1" i="1" baseline="30000" dirty="0"/>
          </a:p>
        </p:txBody>
      </p:sp>
      <p:grpSp>
        <p:nvGrpSpPr>
          <p:cNvPr id="83" name="Group 82">
            <a:extLst>
              <a:ext uri="{FF2B5EF4-FFF2-40B4-BE49-F238E27FC236}">
                <a16:creationId xmlns:a16="http://schemas.microsoft.com/office/drawing/2014/main" id="{39301599-6B33-C6C2-ADDB-D76949531D12}"/>
              </a:ext>
            </a:extLst>
          </p:cNvPr>
          <p:cNvGrpSpPr/>
          <p:nvPr/>
        </p:nvGrpSpPr>
        <p:grpSpPr>
          <a:xfrm>
            <a:off x="539468" y="970765"/>
            <a:ext cx="11113065" cy="4359449"/>
            <a:chOff x="365631" y="701131"/>
            <a:chExt cx="11113065" cy="4359449"/>
          </a:xfrm>
        </p:grpSpPr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086826CA-886D-D22D-2D53-47488F3E2015}"/>
                </a:ext>
              </a:extLst>
            </p:cNvPr>
            <p:cNvGrpSpPr/>
            <p:nvPr/>
          </p:nvGrpSpPr>
          <p:grpSpPr>
            <a:xfrm>
              <a:off x="365631" y="855194"/>
              <a:ext cx="5600383" cy="4052709"/>
              <a:chOff x="576649" y="855194"/>
              <a:chExt cx="5600383" cy="4052709"/>
            </a:xfrm>
          </p:grpSpPr>
          <p:pic>
            <p:nvPicPr>
              <p:cNvPr id="5" name="Picture 4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53A5F2F4-6DD3-0B05-52EC-4602F2E0E9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7" r="7629"/>
              <a:stretch>
                <a:fillRect/>
              </a:stretch>
            </p:blipFill>
            <p:spPr>
              <a:xfrm flipH="1">
                <a:off x="1756432" y="1906763"/>
                <a:ext cx="3170518" cy="3001140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CC29AA9-A8FC-BFAA-0B18-D3F681520CC9}"/>
                  </a:ext>
                </a:extLst>
              </p:cNvPr>
              <p:cNvSpPr txBox="1"/>
              <p:nvPr/>
            </p:nvSpPr>
            <p:spPr>
              <a:xfrm>
                <a:off x="4727520" y="2969941"/>
                <a:ext cx="144951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i="1" dirty="0"/>
                  <a:t>TOTAL UBIQUITIN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FF0DE09E-6F07-681B-BEE5-67D7FB4C9CD9}"/>
                  </a:ext>
                </a:extLst>
              </p:cNvPr>
              <p:cNvSpPr/>
              <p:nvPr/>
            </p:nvSpPr>
            <p:spPr>
              <a:xfrm>
                <a:off x="2125764" y="1918753"/>
                <a:ext cx="2574500" cy="287073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EADE2B7-455B-659E-A5DD-E98F7F740DC6}"/>
                  </a:ext>
                </a:extLst>
              </p:cNvPr>
              <p:cNvSpPr txBox="1"/>
              <p:nvPr/>
            </p:nvSpPr>
            <p:spPr>
              <a:xfrm rot="16200000">
                <a:off x="1725612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1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28C57F8-949A-0CE2-9FDD-BF14D4E80655}"/>
                  </a:ext>
                </a:extLst>
              </p:cNvPr>
              <p:cNvSpPr txBox="1"/>
              <p:nvPr/>
            </p:nvSpPr>
            <p:spPr>
              <a:xfrm rot="16200000">
                <a:off x="1963759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2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8AD6B6D-D766-DD2B-81D3-D7EBA8942E0E}"/>
                  </a:ext>
                </a:extLst>
              </p:cNvPr>
              <p:cNvSpPr txBox="1"/>
              <p:nvPr/>
            </p:nvSpPr>
            <p:spPr>
              <a:xfrm rot="16200000">
                <a:off x="2201906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3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0002650-36DC-9655-24C2-F989230594E3}"/>
                  </a:ext>
                </a:extLst>
              </p:cNvPr>
              <p:cNvSpPr txBox="1"/>
              <p:nvPr/>
            </p:nvSpPr>
            <p:spPr>
              <a:xfrm rot="16200000">
                <a:off x="2440053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4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63D4C6AA-AC7B-57AA-6EC8-F06EA3469038}"/>
                  </a:ext>
                </a:extLst>
              </p:cNvPr>
              <p:cNvSpPr txBox="1"/>
              <p:nvPr/>
            </p:nvSpPr>
            <p:spPr>
              <a:xfrm rot="16200000">
                <a:off x="2678200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5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DDE4A51-0206-A17D-4C68-2AFC533499ED}"/>
                  </a:ext>
                </a:extLst>
              </p:cNvPr>
              <p:cNvSpPr txBox="1"/>
              <p:nvPr/>
            </p:nvSpPr>
            <p:spPr>
              <a:xfrm rot="16200000">
                <a:off x="2916347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6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C6F667F-24A9-F989-81D2-8B4B6448F520}"/>
                  </a:ext>
                </a:extLst>
              </p:cNvPr>
              <p:cNvSpPr txBox="1"/>
              <p:nvPr/>
            </p:nvSpPr>
            <p:spPr>
              <a:xfrm rot="16200000">
                <a:off x="3154494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7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DAFE04D7-7A3D-6232-C077-371EE0F0AF2A}"/>
                  </a:ext>
                </a:extLst>
              </p:cNvPr>
              <p:cNvSpPr txBox="1"/>
              <p:nvPr/>
            </p:nvSpPr>
            <p:spPr>
              <a:xfrm rot="16200000">
                <a:off x="3392641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8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BD88546-2DE1-B6FF-973B-F10DB48E1987}"/>
                  </a:ext>
                </a:extLst>
              </p:cNvPr>
              <p:cNvSpPr txBox="1"/>
              <p:nvPr/>
            </p:nvSpPr>
            <p:spPr>
              <a:xfrm rot="16200000">
                <a:off x="3630788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9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331406D8-F4EF-BA16-A2EA-48E3446842F9}"/>
                  </a:ext>
                </a:extLst>
              </p:cNvPr>
              <p:cNvSpPr txBox="1"/>
              <p:nvPr/>
            </p:nvSpPr>
            <p:spPr>
              <a:xfrm rot="16200000">
                <a:off x="3868935" y="1294255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10</a:t>
                </a:r>
              </a:p>
            </p:txBody>
          </p: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3976B069-65ED-3CD8-41FB-BFE7E7CBEE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22997" y="1315037"/>
                <a:ext cx="105156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61A55C65-A736-DF63-340E-33C183601B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16380" y="1315037"/>
                <a:ext cx="105156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F842D2A-B76C-4E3F-6CF3-484BEE35F682}"/>
                  </a:ext>
                </a:extLst>
              </p:cNvPr>
              <p:cNvSpPr txBox="1"/>
              <p:nvPr/>
            </p:nvSpPr>
            <p:spPr>
              <a:xfrm>
                <a:off x="2361912" y="1111554"/>
                <a:ext cx="778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4BC65DF-9A63-CFE6-5EEA-47F964AF2EFC}"/>
                  </a:ext>
                </a:extLst>
              </p:cNvPr>
              <p:cNvSpPr txBox="1"/>
              <p:nvPr/>
            </p:nvSpPr>
            <p:spPr>
              <a:xfrm>
                <a:off x="3457247" y="1114958"/>
                <a:ext cx="97027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INCRISTINE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A8DECB1E-5525-0902-9C21-6C89EFD64346}"/>
                  </a:ext>
                </a:extLst>
              </p:cNvPr>
              <p:cNvSpPr txBox="1"/>
              <p:nvPr/>
            </p:nvSpPr>
            <p:spPr>
              <a:xfrm>
                <a:off x="576649" y="284416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81CA2EC-4C43-9C58-AEDE-94ACFB12BD7E}"/>
                  </a:ext>
                </a:extLst>
              </p:cNvPr>
              <p:cNvSpPr txBox="1"/>
              <p:nvPr/>
            </p:nvSpPr>
            <p:spPr>
              <a:xfrm>
                <a:off x="576649" y="3050659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EB18C72-0D43-6E29-6435-C06BD5D2C106}"/>
                  </a:ext>
                </a:extLst>
              </p:cNvPr>
              <p:cNvSpPr txBox="1"/>
              <p:nvPr/>
            </p:nvSpPr>
            <p:spPr>
              <a:xfrm>
                <a:off x="576649" y="3270274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4D3A1CCF-27D8-F7D5-C0B1-F4882A206F06}"/>
                  </a:ext>
                </a:extLst>
              </p:cNvPr>
              <p:cNvSpPr txBox="1"/>
              <p:nvPr/>
            </p:nvSpPr>
            <p:spPr>
              <a:xfrm>
                <a:off x="576649" y="3513097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324E7114-067E-59BA-5DCC-6E80176FD206}"/>
                  </a:ext>
                </a:extLst>
              </p:cNvPr>
              <p:cNvSpPr txBox="1"/>
              <p:nvPr/>
            </p:nvSpPr>
            <p:spPr>
              <a:xfrm>
                <a:off x="576649" y="374580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AE0B6BEA-83BF-B22A-1C30-85DD845026C9}"/>
                  </a:ext>
                </a:extLst>
              </p:cNvPr>
              <p:cNvSpPr txBox="1"/>
              <p:nvPr/>
            </p:nvSpPr>
            <p:spPr>
              <a:xfrm>
                <a:off x="576649" y="398358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264BCDE3-2B69-1E2B-9AB1-C3B6A5D37AB8}"/>
                  </a:ext>
                </a:extLst>
              </p:cNvPr>
              <p:cNvSpPr txBox="1"/>
              <p:nvPr/>
            </p:nvSpPr>
            <p:spPr>
              <a:xfrm>
                <a:off x="576649" y="4310716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4660A85-C960-219F-615B-0B15E42E9E97}"/>
                  </a:ext>
                </a:extLst>
              </p:cNvPr>
              <p:cNvSpPr txBox="1"/>
              <p:nvPr/>
            </p:nvSpPr>
            <p:spPr>
              <a:xfrm>
                <a:off x="576649" y="257492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0317BF73-1272-AFA5-F380-B1DD8E31EAE7}"/>
                  </a:ext>
                </a:extLst>
              </p:cNvPr>
              <p:cNvSpPr txBox="1"/>
              <p:nvPr/>
            </p:nvSpPr>
            <p:spPr>
              <a:xfrm>
                <a:off x="576649" y="2352978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23A10433-BDB2-A66B-8772-BABC7E46EBD8}"/>
                </a:ext>
              </a:extLst>
            </p:cNvPr>
            <p:cNvGrpSpPr/>
            <p:nvPr/>
          </p:nvGrpSpPr>
          <p:grpSpPr>
            <a:xfrm>
              <a:off x="6002244" y="701131"/>
              <a:ext cx="5476452" cy="4359449"/>
              <a:chOff x="5586072" y="701131"/>
              <a:chExt cx="5476452" cy="4359449"/>
            </a:xfrm>
          </p:grpSpPr>
          <p:pic>
            <p:nvPicPr>
              <p:cNvPr id="71" name="Picture 70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0202EC82-B368-A526-9967-161B252045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30" t="11927" r="54479" b="13706"/>
              <a:stretch>
                <a:fillRect/>
              </a:stretch>
            </p:blipFill>
            <p:spPr>
              <a:xfrm>
                <a:off x="6805105" y="1765025"/>
                <a:ext cx="2904764" cy="3295555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C7D95622-BAC2-AFAB-4C8C-410D19013A04}"/>
                  </a:ext>
                </a:extLst>
              </p:cNvPr>
              <p:cNvSpPr/>
              <p:nvPr/>
            </p:nvSpPr>
            <p:spPr>
              <a:xfrm>
                <a:off x="7178923" y="3415790"/>
                <a:ext cx="2405358" cy="985759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41DB79B-11F3-A426-1F1A-27862982360E}"/>
                  </a:ext>
                </a:extLst>
              </p:cNvPr>
              <p:cNvSpPr txBox="1"/>
              <p:nvPr/>
            </p:nvSpPr>
            <p:spPr>
              <a:xfrm>
                <a:off x="9613012" y="3609931"/>
                <a:ext cx="144951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i="1" dirty="0"/>
                  <a:t>STAIN FREE BLOT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86F1BFBE-3157-F239-7828-5B5199CF505E}"/>
                  </a:ext>
                </a:extLst>
              </p:cNvPr>
              <p:cNvSpPr txBox="1"/>
              <p:nvPr/>
            </p:nvSpPr>
            <p:spPr>
              <a:xfrm rot="16200000">
                <a:off x="6770358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1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2A52B9D-E07F-D74F-B111-97D9E54E45CA}"/>
                  </a:ext>
                </a:extLst>
              </p:cNvPr>
              <p:cNvSpPr txBox="1"/>
              <p:nvPr/>
            </p:nvSpPr>
            <p:spPr>
              <a:xfrm rot="16200000">
                <a:off x="7008505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2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D075BC9-D0FD-E5B1-6147-3E18706F9ABB}"/>
                  </a:ext>
                </a:extLst>
              </p:cNvPr>
              <p:cNvSpPr txBox="1"/>
              <p:nvPr/>
            </p:nvSpPr>
            <p:spPr>
              <a:xfrm rot="16200000">
                <a:off x="7246652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3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549C87C-1F1E-6ACF-CC4D-4786F0247B8F}"/>
                  </a:ext>
                </a:extLst>
              </p:cNvPr>
              <p:cNvSpPr txBox="1"/>
              <p:nvPr/>
            </p:nvSpPr>
            <p:spPr>
              <a:xfrm rot="16200000">
                <a:off x="7484799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4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29527DB-9C4F-D1A3-3105-93095C855022}"/>
                  </a:ext>
                </a:extLst>
              </p:cNvPr>
              <p:cNvSpPr txBox="1"/>
              <p:nvPr/>
            </p:nvSpPr>
            <p:spPr>
              <a:xfrm rot="16200000">
                <a:off x="7722946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33450712-5D9E-7C83-9DDB-CC30BC7BFC33}"/>
                  </a:ext>
                </a:extLst>
              </p:cNvPr>
              <p:cNvSpPr txBox="1"/>
              <p:nvPr/>
            </p:nvSpPr>
            <p:spPr>
              <a:xfrm rot="16200000">
                <a:off x="7961093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6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11A74B1-B759-0F93-0085-3ED89AF22DC1}"/>
                  </a:ext>
                </a:extLst>
              </p:cNvPr>
              <p:cNvSpPr txBox="1"/>
              <p:nvPr/>
            </p:nvSpPr>
            <p:spPr>
              <a:xfrm rot="16200000">
                <a:off x="8199240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7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4F2D908-2098-D925-A6B7-3BD0FFA65E2A}"/>
                  </a:ext>
                </a:extLst>
              </p:cNvPr>
              <p:cNvSpPr txBox="1"/>
              <p:nvPr/>
            </p:nvSpPr>
            <p:spPr>
              <a:xfrm rot="16200000">
                <a:off x="8437387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8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BC39E7B-BE11-FC61-60D0-39F6CE8C060B}"/>
                  </a:ext>
                </a:extLst>
              </p:cNvPr>
              <p:cNvSpPr txBox="1"/>
              <p:nvPr/>
            </p:nvSpPr>
            <p:spPr>
              <a:xfrm rot="16200000">
                <a:off x="8675534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9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4456EA84-C8CC-C0A8-50CA-33B7934C1F3B}"/>
                  </a:ext>
                </a:extLst>
              </p:cNvPr>
              <p:cNvSpPr txBox="1"/>
              <p:nvPr/>
            </p:nvSpPr>
            <p:spPr>
              <a:xfrm rot="16200000">
                <a:off x="8913681" y="1140192"/>
                <a:ext cx="11089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17.10</a:t>
                </a: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DAC39943-8392-E47E-AC30-6FE2AC9EDC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67743" y="1160974"/>
                <a:ext cx="105156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FA093510-313F-2657-1E97-080B296749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61126" y="1160974"/>
                <a:ext cx="105156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BE870E9-9639-39AD-EE23-385886A33CF8}"/>
                  </a:ext>
                </a:extLst>
              </p:cNvPr>
              <p:cNvSpPr txBox="1"/>
              <p:nvPr/>
            </p:nvSpPr>
            <p:spPr>
              <a:xfrm>
                <a:off x="7406658" y="957491"/>
                <a:ext cx="778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E0FBAFEF-48CB-AB42-68FB-1019D9007361}"/>
                  </a:ext>
                </a:extLst>
              </p:cNvPr>
              <p:cNvSpPr txBox="1"/>
              <p:nvPr/>
            </p:nvSpPr>
            <p:spPr>
              <a:xfrm>
                <a:off x="8501993" y="960895"/>
                <a:ext cx="97027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INCRISTINE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80146406-BCB0-6203-A07E-E115560BB6A7}"/>
                  </a:ext>
                </a:extLst>
              </p:cNvPr>
              <p:cNvSpPr txBox="1"/>
              <p:nvPr/>
            </p:nvSpPr>
            <p:spPr>
              <a:xfrm>
                <a:off x="5586072" y="273760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DECB806-74EE-9DBB-1AFA-3C1293835196}"/>
                  </a:ext>
                </a:extLst>
              </p:cNvPr>
              <p:cNvSpPr txBox="1"/>
              <p:nvPr/>
            </p:nvSpPr>
            <p:spPr>
              <a:xfrm>
                <a:off x="5586072" y="2944101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DC69982-62DE-44C4-19C7-31AE729EB2B4}"/>
                  </a:ext>
                </a:extLst>
              </p:cNvPr>
              <p:cNvSpPr txBox="1"/>
              <p:nvPr/>
            </p:nvSpPr>
            <p:spPr>
              <a:xfrm>
                <a:off x="5586072" y="3163716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87F054F-CF6D-DD84-8CC5-5F3F53D13962}"/>
                  </a:ext>
                </a:extLst>
              </p:cNvPr>
              <p:cNvSpPr txBox="1"/>
              <p:nvPr/>
            </p:nvSpPr>
            <p:spPr>
              <a:xfrm>
                <a:off x="5586072" y="3406539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DB5C3177-01F4-9371-626F-6D2B40507638}"/>
                  </a:ext>
                </a:extLst>
              </p:cNvPr>
              <p:cNvSpPr txBox="1"/>
              <p:nvPr/>
            </p:nvSpPr>
            <p:spPr>
              <a:xfrm>
                <a:off x="5586072" y="363924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C81600A9-470B-EB6A-B838-540D8904194D}"/>
                  </a:ext>
                </a:extLst>
              </p:cNvPr>
              <p:cNvSpPr txBox="1"/>
              <p:nvPr/>
            </p:nvSpPr>
            <p:spPr>
              <a:xfrm>
                <a:off x="5586072" y="3877024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2636ED85-88B7-02E4-C197-49E88C83B788}"/>
                  </a:ext>
                </a:extLst>
              </p:cNvPr>
              <p:cNvSpPr txBox="1"/>
              <p:nvPr/>
            </p:nvSpPr>
            <p:spPr>
              <a:xfrm>
                <a:off x="5586072" y="4204158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D23BAAF9-7819-F70A-9752-5B706B6A8BC1}"/>
                  </a:ext>
                </a:extLst>
              </p:cNvPr>
              <p:cNvSpPr txBox="1"/>
              <p:nvPr/>
            </p:nvSpPr>
            <p:spPr>
              <a:xfrm>
                <a:off x="5586072" y="2468362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B0667C62-78AC-AA4A-85B5-7BCD678B44D2}"/>
                  </a:ext>
                </a:extLst>
              </p:cNvPr>
              <p:cNvSpPr txBox="1"/>
              <p:nvPr/>
            </p:nvSpPr>
            <p:spPr>
              <a:xfrm>
                <a:off x="5586072" y="2246420"/>
                <a:ext cx="12321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054365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FB8432-FEBE-B872-6B35-4314A8086D36}"/>
              </a:ext>
            </a:extLst>
          </p:cNvPr>
          <p:cNvSpPr txBox="1"/>
          <p:nvPr/>
        </p:nvSpPr>
        <p:spPr>
          <a:xfrm>
            <a:off x="1" y="6028238"/>
            <a:ext cx="12191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1. Tissue weights (raw data). (A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eart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Liver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Kidney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Fat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pleen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astrocnemius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Quadriceps, and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ibialis Anterior. Weights are reported as absolute values (mg.). Data expressed as mean ± SD.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t letters denote significant differences: p&lt;0.05. Control (n=5); Vincristine (n=5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DE5FD47-112C-D277-8363-4BB0E2809E18}"/>
              </a:ext>
            </a:extLst>
          </p:cNvPr>
          <p:cNvGrpSpPr/>
          <p:nvPr/>
        </p:nvGrpSpPr>
        <p:grpSpPr>
          <a:xfrm>
            <a:off x="786519" y="-45537"/>
            <a:ext cx="9621838" cy="6254750"/>
            <a:chOff x="786519" y="-45537"/>
            <a:chExt cx="9621838" cy="6254750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37021811-730A-1B63-B0C6-3C31CB06CE5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0785633"/>
                </p:ext>
              </p:extLst>
            </p:nvPr>
          </p:nvGraphicFramePr>
          <p:xfrm>
            <a:off x="786519" y="-45537"/>
            <a:ext cx="9621838" cy="6254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9621746" imgH="6254075" progId="Prism10.Document">
                    <p:embed/>
                  </p:oleObj>
                </mc:Choice>
                <mc:Fallback>
                  <p:oleObj name="Prism 10" r:id="rId2" imgW="9621746" imgH="6254075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37021811-730A-1B63-B0C6-3C31CB06CE5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786519" y="-45537"/>
                          <a:ext cx="9621838" cy="6254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695C8D6-A892-C31E-1EA3-5CF71C7B99CA}"/>
                </a:ext>
              </a:extLst>
            </p:cNvPr>
            <p:cNvSpPr txBox="1"/>
            <p:nvPr/>
          </p:nvSpPr>
          <p:spPr>
            <a:xfrm>
              <a:off x="969012" y="103763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EE20316-B250-8F95-8502-4AB6C5D2A631}"/>
                </a:ext>
              </a:extLst>
            </p:cNvPr>
            <p:cNvSpPr txBox="1"/>
            <p:nvPr/>
          </p:nvSpPr>
          <p:spPr>
            <a:xfrm>
              <a:off x="2814025" y="103763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0E8E322-29A7-045A-FFF9-28672E812767}"/>
                </a:ext>
              </a:extLst>
            </p:cNvPr>
            <p:cNvSpPr txBox="1"/>
            <p:nvPr/>
          </p:nvSpPr>
          <p:spPr>
            <a:xfrm>
              <a:off x="4659038" y="103763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200E89-4E55-B521-3614-5FD290B6A346}"/>
                </a:ext>
              </a:extLst>
            </p:cNvPr>
            <p:cNvSpPr txBox="1"/>
            <p:nvPr/>
          </p:nvSpPr>
          <p:spPr>
            <a:xfrm>
              <a:off x="6504051" y="103763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BEDCEFA-1ABE-A88D-DF0A-ECE01EEF8470}"/>
                </a:ext>
              </a:extLst>
            </p:cNvPr>
            <p:cNvSpPr txBox="1"/>
            <p:nvPr/>
          </p:nvSpPr>
          <p:spPr>
            <a:xfrm>
              <a:off x="8349064" y="103763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3F99594-6F43-8617-31A4-0FA5EA256C13}"/>
                </a:ext>
              </a:extLst>
            </p:cNvPr>
            <p:cNvSpPr txBox="1"/>
            <p:nvPr/>
          </p:nvSpPr>
          <p:spPr>
            <a:xfrm>
              <a:off x="969011" y="3059668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953BD1F-85E6-9BF2-5C11-CA7B51E76300}"/>
                </a:ext>
              </a:extLst>
            </p:cNvPr>
            <p:cNvSpPr txBox="1"/>
            <p:nvPr/>
          </p:nvSpPr>
          <p:spPr>
            <a:xfrm>
              <a:off x="2814024" y="3059668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A92B4B7-09EB-E486-ABBE-D8FFD8D5E8FC}"/>
                </a:ext>
              </a:extLst>
            </p:cNvPr>
            <p:cNvSpPr txBox="1"/>
            <p:nvPr/>
          </p:nvSpPr>
          <p:spPr>
            <a:xfrm>
              <a:off x="4659037" y="3059668"/>
              <a:ext cx="3649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00558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309</Words>
  <Application>Microsoft Office PowerPoint</Application>
  <PresentationFormat>Widescreen</PresentationFormat>
  <Paragraphs>13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mnick, Nicholas</dc:creator>
  <cp:lastModifiedBy>Bonetto, Andrea</cp:lastModifiedBy>
  <cp:revision>1</cp:revision>
  <dcterms:created xsi:type="dcterms:W3CDTF">2025-07-31T17:39:21Z</dcterms:created>
  <dcterms:modified xsi:type="dcterms:W3CDTF">2025-10-24T15:51:48Z</dcterms:modified>
</cp:coreProperties>
</file>